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9144000" cy="6858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980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0A545302-2B77-4B27-879C-E2938CE1C4BE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00FF5A2A-FAA2-4263-826D-44E0F45096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581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054C7-AAFF-4554-8D79-91919F796AE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93216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065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27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6499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850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0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412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6261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229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4960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319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4268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16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7431" y="0"/>
            <a:ext cx="28098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3.</a:t>
            </a:r>
            <a:endParaRPr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1" name="正方形/長方形 100"/>
          <p:cNvSpPr/>
          <p:nvPr/>
        </p:nvSpPr>
        <p:spPr>
          <a:xfrm flipH="1">
            <a:off x="4721008" y="186634"/>
            <a:ext cx="189737" cy="3501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7" name="オブジェクト 6"/>
          <p:cNvGraphicFramePr>
            <a:graphicFrameLocks noChangeAspect="1"/>
          </p:cNvGraphicFramePr>
          <p:nvPr>
            <p:extLst/>
          </p:nvPr>
        </p:nvGraphicFramePr>
        <p:xfrm>
          <a:off x="1530465" y="3877519"/>
          <a:ext cx="2978182" cy="2888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" name="Image" r:id="rId4" imgW="6768000" imgH="6564960" progId="Photoshop.Image.9">
                  <p:embed/>
                </p:oleObj>
              </mc:Choice>
              <mc:Fallback>
                <p:oleObj name="Image" r:id="rId4" imgW="6768000" imgH="6564960" progId="Photoshop.Image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30465" y="3877519"/>
                        <a:ext cx="2978182" cy="2888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オブジェクト 8"/>
          <p:cNvGraphicFramePr>
            <a:graphicFrameLocks noChangeAspect="1"/>
          </p:cNvGraphicFramePr>
          <p:nvPr>
            <p:extLst/>
          </p:nvPr>
        </p:nvGraphicFramePr>
        <p:xfrm>
          <a:off x="1526395" y="941735"/>
          <a:ext cx="2980800" cy="28912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7" name="Image" r:id="rId6" imgW="6768000" imgH="6564960" progId="Photoshop.Image.9">
                  <p:embed/>
                </p:oleObj>
              </mc:Choice>
              <mc:Fallback>
                <p:oleObj name="Image" r:id="rId6" imgW="6768000" imgH="6564960" progId="Photoshop.Image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526395" y="941735"/>
                        <a:ext cx="2980800" cy="28912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オブジェクト 10"/>
          <p:cNvGraphicFramePr>
            <a:graphicFrameLocks noChangeAspect="1"/>
          </p:cNvGraphicFramePr>
          <p:nvPr>
            <p:extLst/>
          </p:nvPr>
        </p:nvGraphicFramePr>
        <p:xfrm>
          <a:off x="4721008" y="948776"/>
          <a:ext cx="3019091" cy="2888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8" name="Image" r:id="rId8" imgW="8241120" imgH="7885440" progId="Photoshop.Image.9">
                  <p:embed/>
                </p:oleObj>
              </mc:Choice>
              <mc:Fallback>
                <p:oleObj name="Image" r:id="rId8" imgW="8241120" imgH="7885440" progId="Photoshop.Image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721008" y="948776"/>
                        <a:ext cx="3019091" cy="2888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オブジェクト 12"/>
          <p:cNvGraphicFramePr>
            <a:graphicFrameLocks noChangeAspect="1"/>
          </p:cNvGraphicFramePr>
          <p:nvPr>
            <p:extLst/>
          </p:nvPr>
        </p:nvGraphicFramePr>
        <p:xfrm>
          <a:off x="4721008" y="3877518"/>
          <a:ext cx="3019091" cy="2888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9" name="Image" r:id="rId10" imgW="8241120" imgH="7885440" progId="Photoshop.Image.9">
                  <p:embed/>
                </p:oleObj>
              </mc:Choice>
              <mc:Fallback>
                <p:oleObj name="Image" r:id="rId10" imgW="8241120" imgH="7885440" progId="Photoshop.Image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721008" y="3877518"/>
                        <a:ext cx="3019091" cy="2888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7" name="直線コネクタ 16"/>
          <p:cNvCxnSpPr/>
          <p:nvPr/>
        </p:nvCxnSpPr>
        <p:spPr>
          <a:xfrm>
            <a:off x="6983406" y="6524701"/>
            <a:ext cx="50405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線コネクタ 114"/>
          <p:cNvCxnSpPr/>
          <p:nvPr/>
        </p:nvCxnSpPr>
        <p:spPr>
          <a:xfrm>
            <a:off x="3753285" y="6509204"/>
            <a:ext cx="583262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正方形/長方形 26"/>
          <p:cNvSpPr/>
          <p:nvPr/>
        </p:nvSpPr>
        <p:spPr>
          <a:xfrm>
            <a:off x="971600" y="3732130"/>
            <a:ext cx="7128792" cy="1453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正方形/長方形 117"/>
          <p:cNvSpPr/>
          <p:nvPr/>
        </p:nvSpPr>
        <p:spPr>
          <a:xfrm>
            <a:off x="1526395" y="6667912"/>
            <a:ext cx="7128792" cy="1453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フリーフォーム 27"/>
          <p:cNvSpPr/>
          <p:nvPr/>
        </p:nvSpPr>
        <p:spPr>
          <a:xfrm>
            <a:off x="2616200" y="1949450"/>
            <a:ext cx="917575" cy="800100"/>
          </a:xfrm>
          <a:custGeom>
            <a:avLst/>
            <a:gdLst>
              <a:gd name="connsiteX0" fmla="*/ 339725 w 917575"/>
              <a:gd name="connsiteY0" fmla="*/ 60325 h 800100"/>
              <a:gd name="connsiteX1" fmla="*/ 285750 w 917575"/>
              <a:gd name="connsiteY1" fmla="*/ 79375 h 800100"/>
              <a:gd name="connsiteX2" fmla="*/ 266700 w 917575"/>
              <a:gd name="connsiteY2" fmla="*/ 92075 h 800100"/>
              <a:gd name="connsiteX3" fmla="*/ 257175 w 917575"/>
              <a:gd name="connsiteY3" fmla="*/ 95250 h 800100"/>
              <a:gd name="connsiteX4" fmla="*/ 238125 w 917575"/>
              <a:gd name="connsiteY4" fmla="*/ 104775 h 800100"/>
              <a:gd name="connsiteX5" fmla="*/ 209550 w 917575"/>
              <a:gd name="connsiteY5" fmla="*/ 127000 h 800100"/>
              <a:gd name="connsiteX6" fmla="*/ 196850 w 917575"/>
              <a:gd name="connsiteY6" fmla="*/ 139700 h 800100"/>
              <a:gd name="connsiteX7" fmla="*/ 187325 w 917575"/>
              <a:gd name="connsiteY7" fmla="*/ 146050 h 800100"/>
              <a:gd name="connsiteX8" fmla="*/ 168275 w 917575"/>
              <a:gd name="connsiteY8" fmla="*/ 168275 h 800100"/>
              <a:gd name="connsiteX9" fmla="*/ 158750 w 917575"/>
              <a:gd name="connsiteY9" fmla="*/ 171450 h 800100"/>
              <a:gd name="connsiteX10" fmla="*/ 155575 w 917575"/>
              <a:gd name="connsiteY10" fmla="*/ 180975 h 800100"/>
              <a:gd name="connsiteX11" fmla="*/ 111125 w 917575"/>
              <a:gd name="connsiteY11" fmla="*/ 219075 h 800100"/>
              <a:gd name="connsiteX12" fmla="*/ 98425 w 917575"/>
              <a:gd name="connsiteY12" fmla="*/ 231775 h 800100"/>
              <a:gd name="connsiteX13" fmla="*/ 79375 w 917575"/>
              <a:gd name="connsiteY13" fmla="*/ 244475 h 800100"/>
              <a:gd name="connsiteX14" fmla="*/ 60325 w 917575"/>
              <a:gd name="connsiteY14" fmla="*/ 266700 h 800100"/>
              <a:gd name="connsiteX15" fmla="*/ 50800 w 917575"/>
              <a:gd name="connsiteY15" fmla="*/ 273050 h 800100"/>
              <a:gd name="connsiteX16" fmla="*/ 38100 w 917575"/>
              <a:gd name="connsiteY16" fmla="*/ 292100 h 800100"/>
              <a:gd name="connsiteX17" fmla="*/ 31750 w 917575"/>
              <a:gd name="connsiteY17" fmla="*/ 301625 h 800100"/>
              <a:gd name="connsiteX18" fmla="*/ 25400 w 917575"/>
              <a:gd name="connsiteY18" fmla="*/ 320675 h 800100"/>
              <a:gd name="connsiteX19" fmla="*/ 12700 w 917575"/>
              <a:gd name="connsiteY19" fmla="*/ 339725 h 800100"/>
              <a:gd name="connsiteX20" fmla="*/ 6350 w 917575"/>
              <a:gd name="connsiteY20" fmla="*/ 349250 h 800100"/>
              <a:gd name="connsiteX21" fmla="*/ 0 w 917575"/>
              <a:gd name="connsiteY21" fmla="*/ 387350 h 800100"/>
              <a:gd name="connsiteX22" fmla="*/ 3175 w 917575"/>
              <a:gd name="connsiteY22" fmla="*/ 447675 h 800100"/>
              <a:gd name="connsiteX23" fmla="*/ 9525 w 917575"/>
              <a:gd name="connsiteY23" fmla="*/ 488950 h 800100"/>
              <a:gd name="connsiteX24" fmla="*/ 15875 w 917575"/>
              <a:gd name="connsiteY24" fmla="*/ 508000 h 800100"/>
              <a:gd name="connsiteX25" fmla="*/ 25400 w 917575"/>
              <a:gd name="connsiteY25" fmla="*/ 530225 h 800100"/>
              <a:gd name="connsiteX26" fmla="*/ 31750 w 917575"/>
              <a:gd name="connsiteY26" fmla="*/ 555625 h 800100"/>
              <a:gd name="connsiteX27" fmla="*/ 53975 w 917575"/>
              <a:gd name="connsiteY27" fmla="*/ 565150 h 800100"/>
              <a:gd name="connsiteX28" fmla="*/ 63500 w 917575"/>
              <a:gd name="connsiteY28" fmla="*/ 568325 h 800100"/>
              <a:gd name="connsiteX29" fmla="*/ 92075 w 917575"/>
              <a:gd name="connsiteY29" fmla="*/ 584200 h 800100"/>
              <a:gd name="connsiteX30" fmla="*/ 111125 w 917575"/>
              <a:gd name="connsiteY30" fmla="*/ 596900 h 800100"/>
              <a:gd name="connsiteX31" fmla="*/ 114300 w 917575"/>
              <a:gd name="connsiteY31" fmla="*/ 606425 h 800100"/>
              <a:gd name="connsiteX32" fmla="*/ 123825 w 917575"/>
              <a:gd name="connsiteY32" fmla="*/ 609600 h 800100"/>
              <a:gd name="connsiteX33" fmla="*/ 133350 w 917575"/>
              <a:gd name="connsiteY33" fmla="*/ 619125 h 800100"/>
              <a:gd name="connsiteX34" fmla="*/ 139700 w 917575"/>
              <a:gd name="connsiteY34" fmla="*/ 638175 h 800100"/>
              <a:gd name="connsiteX35" fmla="*/ 142875 w 917575"/>
              <a:gd name="connsiteY35" fmla="*/ 647700 h 800100"/>
              <a:gd name="connsiteX36" fmla="*/ 155575 w 917575"/>
              <a:gd name="connsiteY36" fmla="*/ 666750 h 800100"/>
              <a:gd name="connsiteX37" fmla="*/ 158750 w 917575"/>
              <a:gd name="connsiteY37" fmla="*/ 676275 h 800100"/>
              <a:gd name="connsiteX38" fmla="*/ 165100 w 917575"/>
              <a:gd name="connsiteY38" fmla="*/ 685800 h 800100"/>
              <a:gd name="connsiteX39" fmla="*/ 168275 w 917575"/>
              <a:gd name="connsiteY39" fmla="*/ 695325 h 800100"/>
              <a:gd name="connsiteX40" fmla="*/ 174625 w 917575"/>
              <a:gd name="connsiteY40" fmla="*/ 704850 h 800100"/>
              <a:gd name="connsiteX41" fmla="*/ 193675 w 917575"/>
              <a:gd name="connsiteY41" fmla="*/ 742950 h 800100"/>
              <a:gd name="connsiteX42" fmla="*/ 203200 w 917575"/>
              <a:gd name="connsiteY42" fmla="*/ 752475 h 800100"/>
              <a:gd name="connsiteX43" fmla="*/ 222250 w 917575"/>
              <a:gd name="connsiteY43" fmla="*/ 758825 h 800100"/>
              <a:gd name="connsiteX44" fmla="*/ 231775 w 917575"/>
              <a:gd name="connsiteY44" fmla="*/ 762000 h 800100"/>
              <a:gd name="connsiteX45" fmla="*/ 257175 w 917575"/>
              <a:gd name="connsiteY45" fmla="*/ 768350 h 800100"/>
              <a:gd name="connsiteX46" fmla="*/ 311150 w 917575"/>
              <a:gd name="connsiteY46" fmla="*/ 774700 h 800100"/>
              <a:gd name="connsiteX47" fmla="*/ 346075 w 917575"/>
              <a:gd name="connsiteY47" fmla="*/ 777875 h 800100"/>
              <a:gd name="connsiteX48" fmla="*/ 374650 w 917575"/>
              <a:gd name="connsiteY48" fmla="*/ 787400 h 800100"/>
              <a:gd name="connsiteX49" fmla="*/ 384175 w 917575"/>
              <a:gd name="connsiteY49" fmla="*/ 790575 h 800100"/>
              <a:gd name="connsiteX50" fmla="*/ 393700 w 917575"/>
              <a:gd name="connsiteY50" fmla="*/ 793750 h 800100"/>
              <a:gd name="connsiteX51" fmla="*/ 422275 w 917575"/>
              <a:gd name="connsiteY51" fmla="*/ 800100 h 800100"/>
              <a:gd name="connsiteX52" fmla="*/ 520700 w 917575"/>
              <a:gd name="connsiteY52" fmla="*/ 796925 h 800100"/>
              <a:gd name="connsiteX53" fmla="*/ 533400 w 917575"/>
              <a:gd name="connsiteY53" fmla="*/ 793750 h 800100"/>
              <a:gd name="connsiteX54" fmla="*/ 558800 w 917575"/>
              <a:gd name="connsiteY54" fmla="*/ 787400 h 800100"/>
              <a:gd name="connsiteX55" fmla="*/ 581025 w 917575"/>
              <a:gd name="connsiteY55" fmla="*/ 781050 h 800100"/>
              <a:gd name="connsiteX56" fmla="*/ 590550 w 917575"/>
              <a:gd name="connsiteY56" fmla="*/ 777875 h 800100"/>
              <a:gd name="connsiteX57" fmla="*/ 600075 w 917575"/>
              <a:gd name="connsiteY57" fmla="*/ 771525 h 800100"/>
              <a:gd name="connsiteX58" fmla="*/ 619125 w 917575"/>
              <a:gd name="connsiteY58" fmla="*/ 765175 h 800100"/>
              <a:gd name="connsiteX59" fmla="*/ 628650 w 917575"/>
              <a:gd name="connsiteY59" fmla="*/ 758825 h 800100"/>
              <a:gd name="connsiteX60" fmla="*/ 638175 w 917575"/>
              <a:gd name="connsiteY60" fmla="*/ 755650 h 800100"/>
              <a:gd name="connsiteX61" fmla="*/ 657225 w 917575"/>
              <a:gd name="connsiteY61" fmla="*/ 742950 h 800100"/>
              <a:gd name="connsiteX62" fmla="*/ 676275 w 917575"/>
              <a:gd name="connsiteY62" fmla="*/ 736600 h 800100"/>
              <a:gd name="connsiteX63" fmla="*/ 685800 w 917575"/>
              <a:gd name="connsiteY63" fmla="*/ 733425 h 800100"/>
              <a:gd name="connsiteX64" fmla="*/ 711200 w 917575"/>
              <a:gd name="connsiteY64" fmla="*/ 717550 h 800100"/>
              <a:gd name="connsiteX65" fmla="*/ 723900 w 917575"/>
              <a:gd name="connsiteY65" fmla="*/ 711200 h 800100"/>
              <a:gd name="connsiteX66" fmla="*/ 736600 w 917575"/>
              <a:gd name="connsiteY66" fmla="*/ 701675 h 800100"/>
              <a:gd name="connsiteX67" fmla="*/ 746125 w 917575"/>
              <a:gd name="connsiteY67" fmla="*/ 695325 h 800100"/>
              <a:gd name="connsiteX68" fmla="*/ 762000 w 917575"/>
              <a:gd name="connsiteY68" fmla="*/ 682625 h 800100"/>
              <a:gd name="connsiteX69" fmla="*/ 781050 w 917575"/>
              <a:gd name="connsiteY69" fmla="*/ 669925 h 800100"/>
              <a:gd name="connsiteX70" fmla="*/ 803275 w 917575"/>
              <a:gd name="connsiteY70" fmla="*/ 638175 h 800100"/>
              <a:gd name="connsiteX71" fmla="*/ 812800 w 917575"/>
              <a:gd name="connsiteY71" fmla="*/ 628650 h 800100"/>
              <a:gd name="connsiteX72" fmla="*/ 819150 w 917575"/>
              <a:gd name="connsiteY72" fmla="*/ 609600 h 800100"/>
              <a:gd name="connsiteX73" fmla="*/ 828675 w 917575"/>
              <a:gd name="connsiteY73" fmla="*/ 568325 h 800100"/>
              <a:gd name="connsiteX74" fmla="*/ 835025 w 917575"/>
              <a:gd name="connsiteY74" fmla="*/ 558800 h 800100"/>
              <a:gd name="connsiteX75" fmla="*/ 844550 w 917575"/>
              <a:gd name="connsiteY75" fmla="*/ 527050 h 800100"/>
              <a:gd name="connsiteX76" fmla="*/ 857250 w 917575"/>
              <a:gd name="connsiteY76" fmla="*/ 501650 h 800100"/>
              <a:gd name="connsiteX77" fmla="*/ 879475 w 917575"/>
              <a:gd name="connsiteY77" fmla="*/ 469900 h 800100"/>
              <a:gd name="connsiteX78" fmla="*/ 889000 w 917575"/>
              <a:gd name="connsiteY78" fmla="*/ 450850 h 800100"/>
              <a:gd name="connsiteX79" fmla="*/ 892175 w 917575"/>
              <a:gd name="connsiteY79" fmla="*/ 441325 h 800100"/>
              <a:gd name="connsiteX80" fmla="*/ 898525 w 917575"/>
              <a:gd name="connsiteY80" fmla="*/ 428625 h 800100"/>
              <a:gd name="connsiteX81" fmla="*/ 904875 w 917575"/>
              <a:gd name="connsiteY81" fmla="*/ 409575 h 800100"/>
              <a:gd name="connsiteX82" fmla="*/ 911225 w 917575"/>
              <a:gd name="connsiteY82" fmla="*/ 390525 h 800100"/>
              <a:gd name="connsiteX83" fmla="*/ 914400 w 917575"/>
              <a:gd name="connsiteY83" fmla="*/ 381000 h 800100"/>
              <a:gd name="connsiteX84" fmla="*/ 917575 w 917575"/>
              <a:gd name="connsiteY84" fmla="*/ 371475 h 800100"/>
              <a:gd name="connsiteX85" fmla="*/ 911225 w 917575"/>
              <a:gd name="connsiteY85" fmla="*/ 282575 h 800100"/>
              <a:gd name="connsiteX86" fmla="*/ 904875 w 917575"/>
              <a:gd name="connsiteY86" fmla="*/ 247650 h 800100"/>
              <a:gd name="connsiteX87" fmla="*/ 898525 w 917575"/>
              <a:gd name="connsiteY87" fmla="*/ 234950 h 800100"/>
              <a:gd name="connsiteX88" fmla="*/ 895350 w 917575"/>
              <a:gd name="connsiteY88" fmla="*/ 225425 h 800100"/>
              <a:gd name="connsiteX89" fmla="*/ 889000 w 917575"/>
              <a:gd name="connsiteY89" fmla="*/ 215900 h 800100"/>
              <a:gd name="connsiteX90" fmla="*/ 882650 w 917575"/>
              <a:gd name="connsiteY90" fmla="*/ 190500 h 800100"/>
              <a:gd name="connsiteX91" fmla="*/ 873125 w 917575"/>
              <a:gd name="connsiteY91" fmla="*/ 177800 h 800100"/>
              <a:gd name="connsiteX92" fmla="*/ 869950 w 917575"/>
              <a:gd name="connsiteY92" fmla="*/ 168275 h 800100"/>
              <a:gd name="connsiteX93" fmla="*/ 863600 w 917575"/>
              <a:gd name="connsiteY93" fmla="*/ 155575 h 800100"/>
              <a:gd name="connsiteX94" fmla="*/ 860425 w 917575"/>
              <a:gd name="connsiteY94" fmla="*/ 142875 h 800100"/>
              <a:gd name="connsiteX95" fmla="*/ 847725 w 917575"/>
              <a:gd name="connsiteY95" fmla="*/ 120650 h 800100"/>
              <a:gd name="connsiteX96" fmla="*/ 844550 w 917575"/>
              <a:gd name="connsiteY96" fmla="*/ 111125 h 800100"/>
              <a:gd name="connsiteX97" fmla="*/ 828675 w 917575"/>
              <a:gd name="connsiteY97" fmla="*/ 92075 h 800100"/>
              <a:gd name="connsiteX98" fmla="*/ 806450 w 917575"/>
              <a:gd name="connsiteY98" fmla="*/ 66675 h 800100"/>
              <a:gd name="connsiteX99" fmla="*/ 790575 w 917575"/>
              <a:gd name="connsiteY99" fmla="*/ 53975 h 800100"/>
              <a:gd name="connsiteX100" fmla="*/ 755650 w 917575"/>
              <a:gd name="connsiteY100" fmla="*/ 31750 h 800100"/>
              <a:gd name="connsiteX101" fmla="*/ 742950 w 917575"/>
              <a:gd name="connsiteY101" fmla="*/ 28575 h 800100"/>
              <a:gd name="connsiteX102" fmla="*/ 723900 w 917575"/>
              <a:gd name="connsiteY102" fmla="*/ 22225 h 800100"/>
              <a:gd name="connsiteX103" fmla="*/ 714375 w 917575"/>
              <a:gd name="connsiteY103" fmla="*/ 19050 h 800100"/>
              <a:gd name="connsiteX104" fmla="*/ 688975 w 917575"/>
              <a:gd name="connsiteY104" fmla="*/ 15875 h 800100"/>
              <a:gd name="connsiteX105" fmla="*/ 673100 w 917575"/>
              <a:gd name="connsiteY105" fmla="*/ 12700 h 800100"/>
              <a:gd name="connsiteX106" fmla="*/ 644525 w 917575"/>
              <a:gd name="connsiteY106" fmla="*/ 9525 h 800100"/>
              <a:gd name="connsiteX107" fmla="*/ 606425 w 917575"/>
              <a:gd name="connsiteY107" fmla="*/ 3175 h 800100"/>
              <a:gd name="connsiteX108" fmla="*/ 581025 w 917575"/>
              <a:gd name="connsiteY108" fmla="*/ 0 h 800100"/>
              <a:gd name="connsiteX109" fmla="*/ 536575 w 917575"/>
              <a:gd name="connsiteY109" fmla="*/ 3175 h 800100"/>
              <a:gd name="connsiteX110" fmla="*/ 517525 w 917575"/>
              <a:gd name="connsiteY110" fmla="*/ 9525 h 800100"/>
              <a:gd name="connsiteX111" fmla="*/ 473075 w 917575"/>
              <a:gd name="connsiteY111" fmla="*/ 22225 h 800100"/>
              <a:gd name="connsiteX112" fmla="*/ 454025 w 917575"/>
              <a:gd name="connsiteY112" fmla="*/ 28575 h 800100"/>
              <a:gd name="connsiteX113" fmla="*/ 444500 w 917575"/>
              <a:gd name="connsiteY113" fmla="*/ 31750 h 800100"/>
              <a:gd name="connsiteX114" fmla="*/ 425450 w 917575"/>
              <a:gd name="connsiteY114" fmla="*/ 34925 h 800100"/>
              <a:gd name="connsiteX115" fmla="*/ 412750 w 917575"/>
              <a:gd name="connsiteY115" fmla="*/ 38100 h 800100"/>
              <a:gd name="connsiteX116" fmla="*/ 368300 w 917575"/>
              <a:gd name="connsiteY116" fmla="*/ 41275 h 800100"/>
              <a:gd name="connsiteX117" fmla="*/ 333375 w 917575"/>
              <a:gd name="connsiteY117" fmla="*/ 50800 h 800100"/>
              <a:gd name="connsiteX118" fmla="*/ 323850 w 917575"/>
              <a:gd name="connsiteY118" fmla="*/ 53975 h 800100"/>
              <a:gd name="connsiteX119" fmla="*/ 339725 w 917575"/>
              <a:gd name="connsiteY119" fmla="*/ 60325 h 800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</a:cxnLst>
            <a:rect l="l" t="t" r="r" b="b"/>
            <a:pathLst>
              <a:path w="917575" h="800100">
                <a:moveTo>
                  <a:pt x="339725" y="60325"/>
                </a:moveTo>
                <a:cubicBezTo>
                  <a:pt x="333375" y="64558"/>
                  <a:pt x="301625" y="68792"/>
                  <a:pt x="285750" y="79375"/>
                </a:cubicBezTo>
                <a:cubicBezTo>
                  <a:pt x="279400" y="83608"/>
                  <a:pt x="273940" y="89662"/>
                  <a:pt x="266700" y="92075"/>
                </a:cubicBezTo>
                <a:cubicBezTo>
                  <a:pt x="263525" y="93133"/>
                  <a:pt x="260168" y="93753"/>
                  <a:pt x="257175" y="95250"/>
                </a:cubicBezTo>
                <a:cubicBezTo>
                  <a:pt x="232556" y="107560"/>
                  <a:pt x="262066" y="96795"/>
                  <a:pt x="238125" y="104775"/>
                </a:cubicBezTo>
                <a:cubicBezTo>
                  <a:pt x="228600" y="112183"/>
                  <a:pt x="218083" y="118467"/>
                  <a:pt x="209550" y="127000"/>
                </a:cubicBezTo>
                <a:cubicBezTo>
                  <a:pt x="205317" y="131233"/>
                  <a:pt x="201396" y="135804"/>
                  <a:pt x="196850" y="139700"/>
                </a:cubicBezTo>
                <a:cubicBezTo>
                  <a:pt x="193953" y="142183"/>
                  <a:pt x="190023" y="143352"/>
                  <a:pt x="187325" y="146050"/>
                </a:cubicBezTo>
                <a:cubicBezTo>
                  <a:pt x="178522" y="154853"/>
                  <a:pt x="178643" y="161363"/>
                  <a:pt x="168275" y="168275"/>
                </a:cubicBezTo>
                <a:cubicBezTo>
                  <a:pt x="165490" y="170131"/>
                  <a:pt x="161925" y="170392"/>
                  <a:pt x="158750" y="171450"/>
                </a:cubicBezTo>
                <a:cubicBezTo>
                  <a:pt x="157692" y="174625"/>
                  <a:pt x="157630" y="178333"/>
                  <a:pt x="155575" y="180975"/>
                </a:cubicBezTo>
                <a:cubicBezTo>
                  <a:pt x="131382" y="212080"/>
                  <a:pt x="140950" y="189250"/>
                  <a:pt x="111125" y="219075"/>
                </a:cubicBezTo>
                <a:cubicBezTo>
                  <a:pt x="106892" y="223308"/>
                  <a:pt x="103100" y="228035"/>
                  <a:pt x="98425" y="231775"/>
                </a:cubicBezTo>
                <a:cubicBezTo>
                  <a:pt x="92466" y="236543"/>
                  <a:pt x="79375" y="244475"/>
                  <a:pt x="79375" y="244475"/>
                </a:cubicBezTo>
                <a:cubicBezTo>
                  <a:pt x="71885" y="255710"/>
                  <a:pt x="72301" y="256435"/>
                  <a:pt x="60325" y="266700"/>
                </a:cubicBezTo>
                <a:cubicBezTo>
                  <a:pt x="57428" y="269183"/>
                  <a:pt x="53975" y="270933"/>
                  <a:pt x="50800" y="273050"/>
                </a:cubicBezTo>
                <a:lnTo>
                  <a:pt x="38100" y="292100"/>
                </a:lnTo>
                <a:cubicBezTo>
                  <a:pt x="35983" y="295275"/>
                  <a:pt x="32957" y="298005"/>
                  <a:pt x="31750" y="301625"/>
                </a:cubicBezTo>
                <a:cubicBezTo>
                  <a:pt x="29633" y="307975"/>
                  <a:pt x="29113" y="315106"/>
                  <a:pt x="25400" y="320675"/>
                </a:cubicBezTo>
                <a:lnTo>
                  <a:pt x="12700" y="339725"/>
                </a:lnTo>
                <a:lnTo>
                  <a:pt x="6350" y="349250"/>
                </a:lnTo>
                <a:cubicBezTo>
                  <a:pt x="4547" y="358264"/>
                  <a:pt x="0" y="379474"/>
                  <a:pt x="0" y="387350"/>
                </a:cubicBezTo>
                <a:cubicBezTo>
                  <a:pt x="0" y="407486"/>
                  <a:pt x="1740" y="427590"/>
                  <a:pt x="3175" y="447675"/>
                </a:cubicBezTo>
                <a:cubicBezTo>
                  <a:pt x="4363" y="464305"/>
                  <a:pt x="5150" y="474366"/>
                  <a:pt x="9525" y="488950"/>
                </a:cubicBezTo>
                <a:cubicBezTo>
                  <a:pt x="11448" y="495361"/>
                  <a:pt x="14252" y="501506"/>
                  <a:pt x="15875" y="508000"/>
                </a:cubicBezTo>
                <a:cubicBezTo>
                  <a:pt x="19975" y="524402"/>
                  <a:pt x="16629" y="517069"/>
                  <a:pt x="25400" y="530225"/>
                </a:cubicBezTo>
                <a:cubicBezTo>
                  <a:pt x="25558" y="531016"/>
                  <a:pt x="29147" y="552371"/>
                  <a:pt x="31750" y="555625"/>
                </a:cubicBezTo>
                <a:cubicBezTo>
                  <a:pt x="37479" y="562786"/>
                  <a:pt x="46066" y="562890"/>
                  <a:pt x="53975" y="565150"/>
                </a:cubicBezTo>
                <a:cubicBezTo>
                  <a:pt x="57193" y="566069"/>
                  <a:pt x="60325" y="567267"/>
                  <a:pt x="63500" y="568325"/>
                </a:cubicBezTo>
                <a:cubicBezTo>
                  <a:pt x="93395" y="598220"/>
                  <a:pt x="45456" y="553120"/>
                  <a:pt x="92075" y="584200"/>
                </a:cubicBezTo>
                <a:lnTo>
                  <a:pt x="111125" y="596900"/>
                </a:lnTo>
                <a:cubicBezTo>
                  <a:pt x="112183" y="600075"/>
                  <a:pt x="111933" y="604058"/>
                  <a:pt x="114300" y="606425"/>
                </a:cubicBezTo>
                <a:cubicBezTo>
                  <a:pt x="116667" y="608792"/>
                  <a:pt x="121040" y="607744"/>
                  <a:pt x="123825" y="609600"/>
                </a:cubicBezTo>
                <a:cubicBezTo>
                  <a:pt x="127561" y="612091"/>
                  <a:pt x="130175" y="615950"/>
                  <a:pt x="133350" y="619125"/>
                </a:cubicBezTo>
                <a:lnTo>
                  <a:pt x="139700" y="638175"/>
                </a:lnTo>
                <a:cubicBezTo>
                  <a:pt x="140758" y="641350"/>
                  <a:pt x="141019" y="644915"/>
                  <a:pt x="142875" y="647700"/>
                </a:cubicBezTo>
                <a:cubicBezTo>
                  <a:pt x="147108" y="654050"/>
                  <a:pt x="153162" y="659510"/>
                  <a:pt x="155575" y="666750"/>
                </a:cubicBezTo>
                <a:cubicBezTo>
                  <a:pt x="156633" y="669925"/>
                  <a:pt x="157253" y="673282"/>
                  <a:pt x="158750" y="676275"/>
                </a:cubicBezTo>
                <a:cubicBezTo>
                  <a:pt x="160457" y="679688"/>
                  <a:pt x="163393" y="682387"/>
                  <a:pt x="165100" y="685800"/>
                </a:cubicBezTo>
                <a:cubicBezTo>
                  <a:pt x="166597" y="688793"/>
                  <a:pt x="166778" y="692332"/>
                  <a:pt x="168275" y="695325"/>
                </a:cubicBezTo>
                <a:cubicBezTo>
                  <a:pt x="169982" y="698738"/>
                  <a:pt x="173075" y="701363"/>
                  <a:pt x="174625" y="704850"/>
                </a:cubicBezTo>
                <a:cubicBezTo>
                  <a:pt x="182888" y="723443"/>
                  <a:pt x="177832" y="727107"/>
                  <a:pt x="193675" y="742950"/>
                </a:cubicBezTo>
                <a:cubicBezTo>
                  <a:pt x="196850" y="746125"/>
                  <a:pt x="199275" y="750294"/>
                  <a:pt x="203200" y="752475"/>
                </a:cubicBezTo>
                <a:cubicBezTo>
                  <a:pt x="209051" y="755726"/>
                  <a:pt x="215900" y="756708"/>
                  <a:pt x="222250" y="758825"/>
                </a:cubicBezTo>
                <a:cubicBezTo>
                  <a:pt x="225425" y="759883"/>
                  <a:pt x="228528" y="761188"/>
                  <a:pt x="231775" y="762000"/>
                </a:cubicBezTo>
                <a:cubicBezTo>
                  <a:pt x="240242" y="764117"/>
                  <a:pt x="248515" y="767268"/>
                  <a:pt x="257175" y="768350"/>
                </a:cubicBezTo>
                <a:cubicBezTo>
                  <a:pt x="277422" y="770881"/>
                  <a:pt x="290564" y="772641"/>
                  <a:pt x="311150" y="774700"/>
                </a:cubicBezTo>
                <a:lnTo>
                  <a:pt x="346075" y="777875"/>
                </a:lnTo>
                <a:lnTo>
                  <a:pt x="374650" y="787400"/>
                </a:lnTo>
                <a:lnTo>
                  <a:pt x="384175" y="790575"/>
                </a:lnTo>
                <a:cubicBezTo>
                  <a:pt x="387350" y="791633"/>
                  <a:pt x="390418" y="793094"/>
                  <a:pt x="393700" y="793750"/>
                </a:cubicBezTo>
                <a:cubicBezTo>
                  <a:pt x="413854" y="797781"/>
                  <a:pt x="404340" y="795616"/>
                  <a:pt x="422275" y="800100"/>
                </a:cubicBezTo>
                <a:cubicBezTo>
                  <a:pt x="455083" y="799042"/>
                  <a:pt x="487928" y="798798"/>
                  <a:pt x="520700" y="796925"/>
                </a:cubicBezTo>
                <a:cubicBezTo>
                  <a:pt x="525057" y="796676"/>
                  <a:pt x="529140" y="794697"/>
                  <a:pt x="533400" y="793750"/>
                </a:cubicBezTo>
                <a:cubicBezTo>
                  <a:pt x="568150" y="786028"/>
                  <a:pt x="534485" y="794695"/>
                  <a:pt x="558800" y="787400"/>
                </a:cubicBezTo>
                <a:cubicBezTo>
                  <a:pt x="566180" y="785186"/>
                  <a:pt x="573645" y="783264"/>
                  <a:pt x="581025" y="781050"/>
                </a:cubicBezTo>
                <a:cubicBezTo>
                  <a:pt x="584231" y="780088"/>
                  <a:pt x="587557" y="779372"/>
                  <a:pt x="590550" y="777875"/>
                </a:cubicBezTo>
                <a:cubicBezTo>
                  <a:pt x="593963" y="776168"/>
                  <a:pt x="596588" y="773075"/>
                  <a:pt x="600075" y="771525"/>
                </a:cubicBezTo>
                <a:cubicBezTo>
                  <a:pt x="606192" y="768807"/>
                  <a:pt x="613556" y="768888"/>
                  <a:pt x="619125" y="765175"/>
                </a:cubicBezTo>
                <a:cubicBezTo>
                  <a:pt x="622300" y="763058"/>
                  <a:pt x="625237" y="760532"/>
                  <a:pt x="628650" y="758825"/>
                </a:cubicBezTo>
                <a:cubicBezTo>
                  <a:pt x="631643" y="757328"/>
                  <a:pt x="635249" y="757275"/>
                  <a:pt x="638175" y="755650"/>
                </a:cubicBezTo>
                <a:cubicBezTo>
                  <a:pt x="644846" y="751944"/>
                  <a:pt x="649985" y="745363"/>
                  <a:pt x="657225" y="742950"/>
                </a:cubicBezTo>
                <a:lnTo>
                  <a:pt x="676275" y="736600"/>
                </a:lnTo>
                <a:lnTo>
                  <a:pt x="685800" y="733425"/>
                </a:lnTo>
                <a:cubicBezTo>
                  <a:pt x="698017" y="715100"/>
                  <a:pt x="684752" y="730774"/>
                  <a:pt x="711200" y="717550"/>
                </a:cubicBezTo>
                <a:cubicBezTo>
                  <a:pt x="715433" y="715433"/>
                  <a:pt x="719886" y="713708"/>
                  <a:pt x="723900" y="711200"/>
                </a:cubicBezTo>
                <a:cubicBezTo>
                  <a:pt x="728387" y="708395"/>
                  <a:pt x="732294" y="704751"/>
                  <a:pt x="736600" y="701675"/>
                </a:cubicBezTo>
                <a:cubicBezTo>
                  <a:pt x="739705" y="699457"/>
                  <a:pt x="743072" y="697615"/>
                  <a:pt x="746125" y="695325"/>
                </a:cubicBezTo>
                <a:cubicBezTo>
                  <a:pt x="751546" y="691259"/>
                  <a:pt x="756519" y="686611"/>
                  <a:pt x="762000" y="682625"/>
                </a:cubicBezTo>
                <a:cubicBezTo>
                  <a:pt x="768172" y="678136"/>
                  <a:pt x="781050" y="669925"/>
                  <a:pt x="781050" y="669925"/>
                </a:cubicBezTo>
                <a:cubicBezTo>
                  <a:pt x="786515" y="661728"/>
                  <a:pt x="796223" y="646402"/>
                  <a:pt x="803275" y="638175"/>
                </a:cubicBezTo>
                <a:cubicBezTo>
                  <a:pt x="806197" y="634766"/>
                  <a:pt x="809625" y="631825"/>
                  <a:pt x="812800" y="628650"/>
                </a:cubicBezTo>
                <a:cubicBezTo>
                  <a:pt x="814917" y="622300"/>
                  <a:pt x="818203" y="616226"/>
                  <a:pt x="819150" y="609600"/>
                </a:cubicBezTo>
                <a:cubicBezTo>
                  <a:pt x="820614" y="599354"/>
                  <a:pt x="822336" y="577834"/>
                  <a:pt x="828675" y="568325"/>
                </a:cubicBezTo>
                <a:lnTo>
                  <a:pt x="835025" y="558800"/>
                </a:lnTo>
                <a:cubicBezTo>
                  <a:pt x="837304" y="549685"/>
                  <a:pt x="840685" y="534780"/>
                  <a:pt x="844550" y="527050"/>
                </a:cubicBezTo>
                <a:cubicBezTo>
                  <a:pt x="848783" y="518583"/>
                  <a:pt x="851570" y="509223"/>
                  <a:pt x="857250" y="501650"/>
                </a:cubicBezTo>
                <a:cubicBezTo>
                  <a:pt x="861597" y="495854"/>
                  <a:pt x="877911" y="474591"/>
                  <a:pt x="879475" y="469900"/>
                </a:cubicBezTo>
                <a:cubicBezTo>
                  <a:pt x="887455" y="445959"/>
                  <a:pt x="876690" y="475469"/>
                  <a:pt x="889000" y="450850"/>
                </a:cubicBezTo>
                <a:cubicBezTo>
                  <a:pt x="890497" y="447857"/>
                  <a:pt x="890857" y="444401"/>
                  <a:pt x="892175" y="441325"/>
                </a:cubicBezTo>
                <a:cubicBezTo>
                  <a:pt x="894039" y="436975"/>
                  <a:pt x="896767" y="433019"/>
                  <a:pt x="898525" y="428625"/>
                </a:cubicBezTo>
                <a:cubicBezTo>
                  <a:pt x="901011" y="422410"/>
                  <a:pt x="902758" y="415925"/>
                  <a:pt x="904875" y="409575"/>
                </a:cubicBezTo>
                <a:lnTo>
                  <a:pt x="911225" y="390525"/>
                </a:lnTo>
                <a:lnTo>
                  <a:pt x="914400" y="381000"/>
                </a:lnTo>
                <a:lnTo>
                  <a:pt x="917575" y="371475"/>
                </a:lnTo>
                <a:cubicBezTo>
                  <a:pt x="913140" y="269462"/>
                  <a:pt x="919406" y="327568"/>
                  <a:pt x="911225" y="282575"/>
                </a:cubicBezTo>
                <a:cubicBezTo>
                  <a:pt x="910585" y="279057"/>
                  <a:pt x="906444" y="252356"/>
                  <a:pt x="904875" y="247650"/>
                </a:cubicBezTo>
                <a:cubicBezTo>
                  <a:pt x="903378" y="243160"/>
                  <a:pt x="900389" y="239300"/>
                  <a:pt x="898525" y="234950"/>
                </a:cubicBezTo>
                <a:cubicBezTo>
                  <a:pt x="897207" y="231874"/>
                  <a:pt x="896847" y="228418"/>
                  <a:pt x="895350" y="225425"/>
                </a:cubicBezTo>
                <a:cubicBezTo>
                  <a:pt x="893643" y="222012"/>
                  <a:pt x="890707" y="219313"/>
                  <a:pt x="889000" y="215900"/>
                </a:cubicBezTo>
                <a:cubicBezTo>
                  <a:pt x="877507" y="192915"/>
                  <a:pt x="897141" y="223106"/>
                  <a:pt x="882650" y="190500"/>
                </a:cubicBezTo>
                <a:cubicBezTo>
                  <a:pt x="880501" y="185664"/>
                  <a:pt x="876300" y="182033"/>
                  <a:pt x="873125" y="177800"/>
                </a:cubicBezTo>
                <a:cubicBezTo>
                  <a:pt x="872067" y="174625"/>
                  <a:pt x="871268" y="171351"/>
                  <a:pt x="869950" y="168275"/>
                </a:cubicBezTo>
                <a:cubicBezTo>
                  <a:pt x="868086" y="163925"/>
                  <a:pt x="865262" y="160007"/>
                  <a:pt x="863600" y="155575"/>
                </a:cubicBezTo>
                <a:cubicBezTo>
                  <a:pt x="862068" y="151489"/>
                  <a:pt x="861957" y="146961"/>
                  <a:pt x="860425" y="142875"/>
                </a:cubicBezTo>
                <a:cubicBezTo>
                  <a:pt x="852076" y="120610"/>
                  <a:pt x="856937" y="139073"/>
                  <a:pt x="847725" y="120650"/>
                </a:cubicBezTo>
                <a:cubicBezTo>
                  <a:pt x="846228" y="117657"/>
                  <a:pt x="846406" y="113910"/>
                  <a:pt x="844550" y="111125"/>
                </a:cubicBezTo>
                <a:cubicBezTo>
                  <a:pt x="818283" y="71725"/>
                  <a:pt x="849450" y="128432"/>
                  <a:pt x="828675" y="92075"/>
                </a:cubicBezTo>
                <a:cubicBezTo>
                  <a:pt x="812522" y="63808"/>
                  <a:pt x="835717" y="95942"/>
                  <a:pt x="806450" y="66675"/>
                </a:cubicBezTo>
                <a:cubicBezTo>
                  <a:pt x="792089" y="52314"/>
                  <a:pt x="809118" y="60156"/>
                  <a:pt x="790575" y="53975"/>
                </a:cubicBezTo>
                <a:cubicBezTo>
                  <a:pt x="779637" y="45771"/>
                  <a:pt x="768651" y="36625"/>
                  <a:pt x="755650" y="31750"/>
                </a:cubicBezTo>
                <a:cubicBezTo>
                  <a:pt x="751564" y="30218"/>
                  <a:pt x="747130" y="29829"/>
                  <a:pt x="742950" y="28575"/>
                </a:cubicBezTo>
                <a:cubicBezTo>
                  <a:pt x="736539" y="26652"/>
                  <a:pt x="730250" y="24342"/>
                  <a:pt x="723900" y="22225"/>
                </a:cubicBezTo>
                <a:cubicBezTo>
                  <a:pt x="720725" y="21167"/>
                  <a:pt x="717696" y="19465"/>
                  <a:pt x="714375" y="19050"/>
                </a:cubicBezTo>
                <a:cubicBezTo>
                  <a:pt x="705908" y="17992"/>
                  <a:pt x="697408" y="17172"/>
                  <a:pt x="688975" y="15875"/>
                </a:cubicBezTo>
                <a:cubicBezTo>
                  <a:pt x="683641" y="15054"/>
                  <a:pt x="678442" y="13463"/>
                  <a:pt x="673100" y="12700"/>
                </a:cubicBezTo>
                <a:cubicBezTo>
                  <a:pt x="663613" y="11345"/>
                  <a:pt x="654035" y="10714"/>
                  <a:pt x="644525" y="9525"/>
                </a:cubicBezTo>
                <a:cubicBezTo>
                  <a:pt x="582518" y="1774"/>
                  <a:pt x="654473" y="10567"/>
                  <a:pt x="606425" y="3175"/>
                </a:cubicBezTo>
                <a:cubicBezTo>
                  <a:pt x="597992" y="1878"/>
                  <a:pt x="589492" y="1058"/>
                  <a:pt x="581025" y="0"/>
                </a:cubicBezTo>
                <a:cubicBezTo>
                  <a:pt x="566208" y="1058"/>
                  <a:pt x="551265" y="971"/>
                  <a:pt x="536575" y="3175"/>
                </a:cubicBezTo>
                <a:cubicBezTo>
                  <a:pt x="529956" y="4168"/>
                  <a:pt x="524019" y="7902"/>
                  <a:pt x="517525" y="9525"/>
                </a:cubicBezTo>
                <a:cubicBezTo>
                  <a:pt x="485631" y="17498"/>
                  <a:pt x="500404" y="13115"/>
                  <a:pt x="473075" y="22225"/>
                </a:cubicBezTo>
                <a:lnTo>
                  <a:pt x="454025" y="28575"/>
                </a:lnTo>
                <a:cubicBezTo>
                  <a:pt x="450850" y="29633"/>
                  <a:pt x="447801" y="31200"/>
                  <a:pt x="444500" y="31750"/>
                </a:cubicBezTo>
                <a:cubicBezTo>
                  <a:pt x="438150" y="32808"/>
                  <a:pt x="431763" y="33662"/>
                  <a:pt x="425450" y="34925"/>
                </a:cubicBezTo>
                <a:cubicBezTo>
                  <a:pt x="421171" y="35781"/>
                  <a:pt x="417087" y="37618"/>
                  <a:pt x="412750" y="38100"/>
                </a:cubicBezTo>
                <a:cubicBezTo>
                  <a:pt x="397986" y="39740"/>
                  <a:pt x="383117" y="40217"/>
                  <a:pt x="368300" y="41275"/>
                </a:cubicBezTo>
                <a:cubicBezTo>
                  <a:pt x="345861" y="45763"/>
                  <a:pt x="357545" y="42743"/>
                  <a:pt x="333375" y="50800"/>
                </a:cubicBezTo>
                <a:cubicBezTo>
                  <a:pt x="330200" y="51858"/>
                  <a:pt x="326635" y="52119"/>
                  <a:pt x="323850" y="53975"/>
                </a:cubicBezTo>
                <a:cubicBezTo>
                  <a:pt x="313080" y="61155"/>
                  <a:pt x="346075" y="56092"/>
                  <a:pt x="339725" y="60325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フリーフォーム 119"/>
          <p:cNvSpPr/>
          <p:nvPr/>
        </p:nvSpPr>
        <p:spPr>
          <a:xfrm>
            <a:off x="2627784" y="4874965"/>
            <a:ext cx="917575" cy="800100"/>
          </a:xfrm>
          <a:custGeom>
            <a:avLst/>
            <a:gdLst>
              <a:gd name="connsiteX0" fmla="*/ 339725 w 917575"/>
              <a:gd name="connsiteY0" fmla="*/ 60325 h 800100"/>
              <a:gd name="connsiteX1" fmla="*/ 285750 w 917575"/>
              <a:gd name="connsiteY1" fmla="*/ 79375 h 800100"/>
              <a:gd name="connsiteX2" fmla="*/ 266700 w 917575"/>
              <a:gd name="connsiteY2" fmla="*/ 92075 h 800100"/>
              <a:gd name="connsiteX3" fmla="*/ 257175 w 917575"/>
              <a:gd name="connsiteY3" fmla="*/ 95250 h 800100"/>
              <a:gd name="connsiteX4" fmla="*/ 238125 w 917575"/>
              <a:gd name="connsiteY4" fmla="*/ 104775 h 800100"/>
              <a:gd name="connsiteX5" fmla="*/ 209550 w 917575"/>
              <a:gd name="connsiteY5" fmla="*/ 127000 h 800100"/>
              <a:gd name="connsiteX6" fmla="*/ 196850 w 917575"/>
              <a:gd name="connsiteY6" fmla="*/ 139700 h 800100"/>
              <a:gd name="connsiteX7" fmla="*/ 187325 w 917575"/>
              <a:gd name="connsiteY7" fmla="*/ 146050 h 800100"/>
              <a:gd name="connsiteX8" fmla="*/ 168275 w 917575"/>
              <a:gd name="connsiteY8" fmla="*/ 168275 h 800100"/>
              <a:gd name="connsiteX9" fmla="*/ 158750 w 917575"/>
              <a:gd name="connsiteY9" fmla="*/ 171450 h 800100"/>
              <a:gd name="connsiteX10" fmla="*/ 155575 w 917575"/>
              <a:gd name="connsiteY10" fmla="*/ 180975 h 800100"/>
              <a:gd name="connsiteX11" fmla="*/ 111125 w 917575"/>
              <a:gd name="connsiteY11" fmla="*/ 219075 h 800100"/>
              <a:gd name="connsiteX12" fmla="*/ 98425 w 917575"/>
              <a:gd name="connsiteY12" fmla="*/ 231775 h 800100"/>
              <a:gd name="connsiteX13" fmla="*/ 79375 w 917575"/>
              <a:gd name="connsiteY13" fmla="*/ 244475 h 800100"/>
              <a:gd name="connsiteX14" fmla="*/ 60325 w 917575"/>
              <a:gd name="connsiteY14" fmla="*/ 266700 h 800100"/>
              <a:gd name="connsiteX15" fmla="*/ 50800 w 917575"/>
              <a:gd name="connsiteY15" fmla="*/ 273050 h 800100"/>
              <a:gd name="connsiteX16" fmla="*/ 38100 w 917575"/>
              <a:gd name="connsiteY16" fmla="*/ 292100 h 800100"/>
              <a:gd name="connsiteX17" fmla="*/ 31750 w 917575"/>
              <a:gd name="connsiteY17" fmla="*/ 301625 h 800100"/>
              <a:gd name="connsiteX18" fmla="*/ 25400 w 917575"/>
              <a:gd name="connsiteY18" fmla="*/ 320675 h 800100"/>
              <a:gd name="connsiteX19" fmla="*/ 12700 w 917575"/>
              <a:gd name="connsiteY19" fmla="*/ 339725 h 800100"/>
              <a:gd name="connsiteX20" fmla="*/ 6350 w 917575"/>
              <a:gd name="connsiteY20" fmla="*/ 349250 h 800100"/>
              <a:gd name="connsiteX21" fmla="*/ 0 w 917575"/>
              <a:gd name="connsiteY21" fmla="*/ 387350 h 800100"/>
              <a:gd name="connsiteX22" fmla="*/ 3175 w 917575"/>
              <a:gd name="connsiteY22" fmla="*/ 447675 h 800100"/>
              <a:gd name="connsiteX23" fmla="*/ 9525 w 917575"/>
              <a:gd name="connsiteY23" fmla="*/ 488950 h 800100"/>
              <a:gd name="connsiteX24" fmla="*/ 15875 w 917575"/>
              <a:gd name="connsiteY24" fmla="*/ 508000 h 800100"/>
              <a:gd name="connsiteX25" fmla="*/ 25400 w 917575"/>
              <a:gd name="connsiteY25" fmla="*/ 530225 h 800100"/>
              <a:gd name="connsiteX26" fmla="*/ 31750 w 917575"/>
              <a:gd name="connsiteY26" fmla="*/ 555625 h 800100"/>
              <a:gd name="connsiteX27" fmla="*/ 53975 w 917575"/>
              <a:gd name="connsiteY27" fmla="*/ 565150 h 800100"/>
              <a:gd name="connsiteX28" fmla="*/ 63500 w 917575"/>
              <a:gd name="connsiteY28" fmla="*/ 568325 h 800100"/>
              <a:gd name="connsiteX29" fmla="*/ 92075 w 917575"/>
              <a:gd name="connsiteY29" fmla="*/ 584200 h 800100"/>
              <a:gd name="connsiteX30" fmla="*/ 111125 w 917575"/>
              <a:gd name="connsiteY30" fmla="*/ 596900 h 800100"/>
              <a:gd name="connsiteX31" fmla="*/ 114300 w 917575"/>
              <a:gd name="connsiteY31" fmla="*/ 606425 h 800100"/>
              <a:gd name="connsiteX32" fmla="*/ 123825 w 917575"/>
              <a:gd name="connsiteY32" fmla="*/ 609600 h 800100"/>
              <a:gd name="connsiteX33" fmla="*/ 133350 w 917575"/>
              <a:gd name="connsiteY33" fmla="*/ 619125 h 800100"/>
              <a:gd name="connsiteX34" fmla="*/ 139700 w 917575"/>
              <a:gd name="connsiteY34" fmla="*/ 638175 h 800100"/>
              <a:gd name="connsiteX35" fmla="*/ 142875 w 917575"/>
              <a:gd name="connsiteY35" fmla="*/ 647700 h 800100"/>
              <a:gd name="connsiteX36" fmla="*/ 155575 w 917575"/>
              <a:gd name="connsiteY36" fmla="*/ 666750 h 800100"/>
              <a:gd name="connsiteX37" fmla="*/ 158750 w 917575"/>
              <a:gd name="connsiteY37" fmla="*/ 676275 h 800100"/>
              <a:gd name="connsiteX38" fmla="*/ 165100 w 917575"/>
              <a:gd name="connsiteY38" fmla="*/ 685800 h 800100"/>
              <a:gd name="connsiteX39" fmla="*/ 168275 w 917575"/>
              <a:gd name="connsiteY39" fmla="*/ 695325 h 800100"/>
              <a:gd name="connsiteX40" fmla="*/ 174625 w 917575"/>
              <a:gd name="connsiteY40" fmla="*/ 704850 h 800100"/>
              <a:gd name="connsiteX41" fmla="*/ 193675 w 917575"/>
              <a:gd name="connsiteY41" fmla="*/ 742950 h 800100"/>
              <a:gd name="connsiteX42" fmla="*/ 203200 w 917575"/>
              <a:gd name="connsiteY42" fmla="*/ 752475 h 800100"/>
              <a:gd name="connsiteX43" fmla="*/ 222250 w 917575"/>
              <a:gd name="connsiteY43" fmla="*/ 758825 h 800100"/>
              <a:gd name="connsiteX44" fmla="*/ 231775 w 917575"/>
              <a:gd name="connsiteY44" fmla="*/ 762000 h 800100"/>
              <a:gd name="connsiteX45" fmla="*/ 257175 w 917575"/>
              <a:gd name="connsiteY45" fmla="*/ 768350 h 800100"/>
              <a:gd name="connsiteX46" fmla="*/ 311150 w 917575"/>
              <a:gd name="connsiteY46" fmla="*/ 774700 h 800100"/>
              <a:gd name="connsiteX47" fmla="*/ 346075 w 917575"/>
              <a:gd name="connsiteY47" fmla="*/ 777875 h 800100"/>
              <a:gd name="connsiteX48" fmla="*/ 374650 w 917575"/>
              <a:gd name="connsiteY48" fmla="*/ 787400 h 800100"/>
              <a:gd name="connsiteX49" fmla="*/ 384175 w 917575"/>
              <a:gd name="connsiteY49" fmla="*/ 790575 h 800100"/>
              <a:gd name="connsiteX50" fmla="*/ 393700 w 917575"/>
              <a:gd name="connsiteY50" fmla="*/ 793750 h 800100"/>
              <a:gd name="connsiteX51" fmla="*/ 422275 w 917575"/>
              <a:gd name="connsiteY51" fmla="*/ 800100 h 800100"/>
              <a:gd name="connsiteX52" fmla="*/ 520700 w 917575"/>
              <a:gd name="connsiteY52" fmla="*/ 796925 h 800100"/>
              <a:gd name="connsiteX53" fmla="*/ 533400 w 917575"/>
              <a:gd name="connsiteY53" fmla="*/ 793750 h 800100"/>
              <a:gd name="connsiteX54" fmla="*/ 558800 w 917575"/>
              <a:gd name="connsiteY54" fmla="*/ 787400 h 800100"/>
              <a:gd name="connsiteX55" fmla="*/ 581025 w 917575"/>
              <a:gd name="connsiteY55" fmla="*/ 781050 h 800100"/>
              <a:gd name="connsiteX56" fmla="*/ 590550 w 917575"/>
              <a:gd name="connsiteY56" fmla="*/ 777875 h 800100"/>
              <a:gd name="connsiteX57" fmla="*/ 600075 w 917575"/>
              <a:gd name="connsiteY57" fmla="*/ 771525 h 800100"/>
              <a:gd name="connsiteX58" fmla="*/ 619125 w 917575"/>
              <a:gd name="connsiteY58" fmla="*/ 765175 h 800100"/>
              <a:gd name="connsiteX59" fmla="*/ 628650 w 917575"/>
              <a:gd name="connsiteY59" fmla="*/ 758825 h 800100"/>
              <a:gd name="connsiteX60" fmla="*/ 638175 w 917575"/>
              <a:gd name="connsiteY60" fmla="*/ 755650 h 800100"/>
              <a:gd name="connsiteX61" fmla="*/ 657225 w 917575"/>
              <a:gd name="connsiteY61" fmla="*/ 742950 h 800100"/>
              <a:gd name="connsiteX62" fmla="*/ 676275 w 917575"/>
              <a:gd name="connsiteY62" fmla="*/ 736600 h 800100"/>
              <a:gd name="connsiteX63" fmla="*/ 685800 w 917575"/>
              <a:gd name="connsiteY63" fmla="*/ 733425 h 800100"/>
              <a:gd name="connsiteX64" fmla="*/ 711200 w 917575"/>
              <a:gd name="connsiteY64" fmla="*/ 717550 h 800100"/>
              <a:gd name="connsiteX65" fmla="*/ 723900 w 917575"/>
              <a:gd name="connsiteY65" fmla="*/ 711200 h 800100"/>
              <a:gd name="connsiteX66" fmla="*/ 736600 w 917575"/>
              <a:gd name="connsiteY66" fmla="*/ 701675 h 800100"/>
              <a:gd name="connsiteX67" fmla="*/ 746125 w 917575"/>
              <a:gd name="connsiteY67" fmla="*/ 695325 h 800100"/>
              <a:gd name="connsiteX68" fmla="*/ 762000 w 917575"/>
              <a:gd name="connsiteY68" fmla="*/ 682625 h 800100"/>
              <a:gd name="connsiteX69" fmla="*/ 781050 w 917575"/>
              <a:gd name="connsiteY69" fmla="*/ 669925 h 800100"/>
              <a:gd name="connsiteX70" fmla="*/ 803275 w 917575"/>
              <a:gd name="connsiteY70" fmla="*/ 638175 h 800100"/>
              <a:gd name="connsiteX71" fmla="*/ 812800 w 917575"/>
              <a:gd name="connsiteY71" fmla="*/ 628650 h 800100"/>
              <a:gd name="connsiteX72" fmla="*/ 819150 w 917575"/>
              <a:gd name="connsiteY72" fmla="*/ 609600 h 800100"/>
              <a:gd name="connsiteX73" fmla="*/ 828675 w 917575"/>
              <a:gd name="connsiteY73" fmla="*/ 568325 h 800100"/>
              <a:gd name="connsiteX74" fmla="*/ 835025 w 917575"/>
              <a:gd name="connsiteY74" fmla="*/ 558800 h 800100"/>
              <a:gd name="connsiteX75" fmla="*/ 844550 w 917575"/>
              <a:gd name="connsiteY75" fmla="*/ 527050 h 800100"/>
              <a:gd name="connsiteX76" fmla="*/ 857250 w 917575"/>
              <a:gd name="connsiteY76" fmla="*/ 501650 h 800100"/>
              <a:gd name="connsiteX77" fmla="*/ 879475 w 917575"/>
              <a:gd name="connsiteY77" fmla="*/ 469900 h 800100"/>
              <a:gd name="connsiteX78" fmla="*/ 889000 w 917575"/>
              <a:gd name="connsiteY78" fmla="*/ 450850 h 800100"/>
              <a:gd name="connsiteX79" fmla="*/ 892175 w 917575"/>
              <a:gd name="connsiteY79" fmla="*/ 441325 h 800100"/>
              <a:gd name="connsiteX80" fmla="*/ 898525 w 917575"/>
              <a:gd name="connsiteY80" fmla="*/ 428625 h 800100"/>
              <a:gd name="connsiteX81" fmla="*/ 904875 w 917575"/>
              <a:gd name="connsiteY81" fmla="*/ 409575 h 800100"/>
              <a:gd name="connsiteX82" fmla="*/ 911225 w 917575"/>
              <a:gd name="connsiteY82" fmla="*/ 390525 h 800100"/>
              <a:gd name="connsiteX83" fmla="*/ 914400 w 917575"/>
              <a:gd name="connsiteY83" fmla="*/ 381000 h 800100"/>
              <a:gd name="connsiteX84" fmla="*/ 917575 w 917575"/>
              <a:gd name="connsiteY84" fmla="*/ 371475 h 800100"/>
              <a:gd name="connsiteX85" fmla="*/ 911225 w 917575"/>
              <a:gd name="connsiteY85" fmla="*/ 282575 h 800100"/>
              <a:gd name="connsiteX86" fmla="*/ 904875 w 917575"/>
              <a:gd name="connsiteY86" fmla="*/ 247650 h 800100"/>
              <a:gd name="connsiteX87" fmla="*/ 898525 w 917575"/>
              <a:gd name="connsiteY87" fmla="*/ 234950 h 800100"/>
              <a:gd name="connsiteX88" fmla="*/ 895350 w 917575"/>
              <a:gd name="connsiteY88" fmla="*/ 225425 h 800100"/>
              <a:gd name="connsiteX89" fmla="*/ 889000 w 917575"/>
              <a:gd name="connsiteY89" fmla="*/ 215900 h 800100"/>
              <a:gd name="connsiteX90" fmla="*/ 882650 w 917575"/>
              <a:gd name="connsiteY90" fmla="*/ 190500 h 800100"/>
              <a:gd name="connsiteX91" fmla="*/ 873125 w 917575"/>
              <a:gd name="connsiteY91" fmla="*/ 177800 h 800100"/>
              <a:gd name="connsiteX92" fmla="*/ 869950 w 917575"/>
              <a:gd name="connsiteY92" fmla="*/ 168275 h 800100"/>
              <a:gd name="connsiteX93" fmla="*/ 863600 w 917575"/>
              <a:gd name="connsiteY93" fmla="*/ 155575 h 800100"/>
              <a:gd name="connsiteX94" fmla="*/ 860425 w 917575"/>
              <a:gd name="connsiteY94" fmla="*/ 142875 h 800100"/>
              <a:gd name="connsiteX95" fmla="*/ 847725 w 917575"/>
              <a:gd name="connsiteY95" fmla="*/ 120650 h 800100"/>
              <a:gd name="connsiteX96" fmla="*/ 844550 w 917575"/>
              <a:gd name="connsiteY96" fmla="*/ 111125 h 800100"/>
              <a:gd name="connsiteX97" fmla="*/ 828675 w 917575"/>
              <a:gd name="connsiteY97" fmla="*/ 92075 h 800100"/>
              <a:gd name="connsiteX98" fmla="*/ 806450 w 917575"/>
              <a:gd name="connsiteY98" fmla="*/ 66675 h 800100"/>
              <a:gd name="connsiteX99" fmla="*/ 790575 w 917575"/>
              <a:gd name="connsiteY99" fmla="*/ 53975 h 800100"/>
              <a:gd name="connsiteX100" fmla="*/ 755650 w 917575"/>
              <a:gd name="connsiteY100" fmla="*/ 31750 h 800100"/>
              <a:gd name="connsiteX101" fmla="*/ 742950 w 917575"/>
              <a:gd name="connsiteY101" fmla="*/ 28575 h 800100"/>
              <a:gd name="connsiteX102" fmla="*/ 723900 w 917575"/>
              <a:gd name="connsiteY102" fmla="*/ 22225 h 800100"/>
              <a:gd name="connsiteX103" fmla="*/ 714375 w 917575"/>
              <a:gd name="connsiteY103" fmla="*/ 19050 h 800100"/>
              <a:gd name="connsiteX104" fmla="*/ 688975 w 917575"/>
              <a:gd name="connsiteY104" fmla="*/ 15875 h 800100"/>
              <a:gd name="connsiteX105" fmla="*/ 673100 w 917575"/>
              <a:gd name="connsiteY105" fmla="*/ 12700 h 800100"/>
              <a:gd name="connsiteX106" fmla="*/ 644525 w 917575"/>
              <a:gd name="connsiteY106" fmla="*/ 9525 h 800100"/>
              <a:gd name="connsiteX107" fmla="*/ 606425 w 917575"/>
              <a:gd name="connsiteY107" fmla="*/ 3175 h 800100"/>
              <a:gd name="connsiteX108" fmla="*/ 581025 w 917575"/>
              <a:gd name="connsiteY108" fmla="*/ 0 h 800100"/>
              <a:gd name="connsiteX109" fmla="*/ 536575 w 917575"/>
              <a:gd name="connsiteY109" fmla="*/ 3175 h 800100"/>
              <a:gd name="connsiteX110" fmla="*/ 517525 w 917575"/>
              <a:gd name="connsiteY110" fmla="*/ 9525 h 800100"/>
              <a:gd name="connsiteX111" fmla="*/ 473075 w 917575"/>
              <a:gd name="connsiteY111" fmla="*/ 22225 h 800100"/>
              <a:gd name="connsiteX112" fmla="*/ 454025 w 917575"/>
              <a:gd name="connsiteY112" fmla="*/ 28575 h 800100"/>
              <a:gd name="connsiteX113" fmla="*/ 444500 w 917575"/>
              <a:gd name="connsiteY113" fmla="*/ 31750 h 800100"/>
              <a:gd name="connsiteX114" fmla="*/ 425450 w 917575"/>
              <a:gd name="connsiteY114" fmla="*/ 34925 h 800100"/>
              <a:gd name="connsiteX115" fmla="*/ 412750 w 917575"/>
              <a:gd name="connsiteY115" fmla="*/ 38100 h 800100"/>
              <a:gd name="connsiteX116" fmla="*/ 368300 w 917575"/>
              <a:gd name="connsiteY116" fmla="*/ 41275 h 800100"/>
              <a:gd name="connsiteX117" fmla="*/ 333375 w 917575"/>
              <a:gd name="connsiteY117" fmla="*/ 50800 h 800100"/>
              <a:gd name="connsiteX118" fmla="*/ 323850 w 917575"/>
              <a:gd name="connsiteY118" fmla="*/ 53975 h 800100"/>
              <a:gd name="connsiteX119" fmla="*/ 339725 w 917575"/>
              <a:gd name="connsiteY119" fmla="*/ 60325 h 800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</a:cxnLst>
            <a:rect l="l" t="t" r="r" b="b"/>
            <a:pathLst>
              <a:path w="917575" h="800100">
                <a:moveTo>
                  <a:pt x="339725" y="60325"/>
                </a:moveTo>
                <a:cubicBezTo>
                  <a:pt x="333375" y="64558"/>
                  <a:pt x="301625" y="68792"/>
                  <a:pt x="285750" y="79375"/>
                </a:cubicBezTo>
                <a:cubicBezTo>
                  <a:pt x="279400" y="83608"/>
                  <a:pt x="273940" y="89662"/>
                  <a:pt x="266700" y="92075"/>
                </a:cubicBezTo>
                <a:cubicBezTo>
                  <a:pt x="263525" y="93133"/>
                  <a:pt x="260168" y="93753"/>
                  <a:pt x="257175" y="95250"/>
                </a:cubicBezTo>
                <a:cubicBezTo>
                  <a:pt x="232556" y="107560"/>
                  <a:pt x="262066" y="96795"/>
                  <a:pt x="238125" y="104775"/>
                </a:cubicBezTo>
                <a:cubicBezTo>
                  <a:pt x="228600" y="112183"/>
                  <a:pt x="218083" y="118467"/>
                  <a:pt x="209550" y="127000"/>
                </a:cubicBezTo>
                <a:cubicBezTo>
                  <a:pt x="205317" y="131233"/>
                  <a:pt x="201396" y="135804"/>
                  <a:pt x="196850" y="139700"/>
                </a:cubicBezTo>
                <a:cubicBezTo>
                  <a:pt x="193953" y="142183"/>
                  <a:pt x="190023" y="143352"/>
                  <a:pt x="187325" y="146050"/>
                </a:cubicBezTo>
                <a:cubicBezTo>
                  <a:pt x="178522" y="154853"/>
                  <a:pt x="178643" y="161363"/>
                  <a:pt x="168275" y="168275"/>
                </a:cubicBezTo>
                <a:cubicBezTo>
                  <a:pt x="165490" y="170131"/>
                  <a:pt x="161925" y="170392"/>
                  <a:pt x="158750" y="171450"/>
                </a:cubicBezTo>
                <a:cubicBezTo>
                  <a:pt x="157692" y="174625"/>
                  <a:pt x="157630" y="178333"/>
                  <a:pt x="155575" y="180975"/>
                </a:cubicBezTo>
                <a:cubicBezTo>
                  <a:pt x="131382" y="212080"/>
                  <a:pt x="140950" y="189250"/>
                  <a:pt x="111125" y="219075"/>
                </a:cubicBezTo>
                <a:cubicBezTo>
                  <a:pt x="106892" y="223308"/>
                  <a:pt x="103100" y="228035"/>
                  <a:pt x="98425" y="231775"/>
                </a:cubicBezTo>
                <a:cubicBezTo>
                  <a:pt x="92466" y="236543"/>
                  <a:pt x="79375" y="244475"/>
                  <a:pt x="79375" y="244475"/>
                </a:cubicBezTo>
                <a:cubicBezTo>
                  <a:pt x="71885" y="255710"/>
                  <a:pt x="72301" y="256435"/>
                  <a:pt x="60325" y="266700"/>
                </a:cubicBezTo>
                <a:cubicBezTo>
                  <a:pt x="57428" y="269183"/>
                  <a:pt x="53975" y="270933"/>
                  <a:pt x="50800" y="273050"/>
                </a:cubicBezTo>
                <a:lnTo>
                  <a:pt x="38100" y="292100"/>
                </a:lnTo>
                <a:cubicBezTo>
                  <a:pt x="35983" y="295275"/>
                  <a:pt x="32957" y="298005"/>
                  <a:pt x="31750" y="301625"/>
                </a:cubicBezTo>
                <a:cubicBezTo>
                  <a:pt x="29633" y="307975"/>
                  <a:pt x="29113" y="315106"/>
                  <a:pt x="25400" y="320675"/>
                </a:cubicBezTo>
                <a:lnTo>
                  <a:pt x="12700" y="339725"/>
                </a:lnTo>
                <a:lnTo>
                  <a:pt x="6350" y="349250"/>
                </a:lnTo>
                <a:cubicBezTo>
                  <a:pt x="4547" y="358264"/>
                  <a:pt x="0" y="379474"/>
                  <a:pt x="0" y="387350"/>
                </a:cubicBezTo>
                <a:cubicBezTo>
                  <a:pt x="0" y="407486"/>
                  <a:pt x="1740" y="427590"/>
                  <a:pt x="3175" y="447675"/>
                </a:cubicBezTo>
                <a:cubicBezTo>
                  <a:pt x="4363" y="464305"/>
                  <a:pt x="5150" y="474366"/>
                  <a:pt x="9525" y="488950"/>
                </a:cubicBezTo>
                <a:cubicBezTo>
                  <a:pt x="11448" y="495361"/>
                  <a:pt x="14252" y="501506"/>
                  <a:pt x="15875" y="508000"/>
                </a:cubicBezTo>
                <a:cubicBezTo>
                  <a:pt x="19975" y="524402"/>
                  <a:pt x="16629" y="517069"/>
                  <a:pt x="25400" y="530225"/>
                </a:cubicBezTo>
                <a:cubicBezTo>
                  <a:pt x="25558" y="531016"/>
                  <a:pt x="29147" y="552371"/>
                  <a:pt x="31750" y="555625"/>
                </a:cubicBezTo>
                <a:cubicBezTo>
                  <a:pt x="37479" y="562786"/>
                  <a:pt x="46066" y="562890"/>
                  <a:pt x="53975" y="565150"/>
                </a:cubicBezTo>
                <a:cubicBezTo>
                  <a:pt x="57193" y="566069"/>
                  <a:pt x="60325" y="567267"/>
                  <a:pt x="63500" y="568325"/>
                </a:cubicBezTo>
                <a:cubicBezTo>
                  <a:pt x="93395" y="598220"/>
                  <a:pt x="45456" y="553120"/>
                  <a:pt x="92075" y="584200"/>
                </a:cubicBezTo>
                <a:lnTo>
                  <a:pt x="111125" y="596900"/>
                </a:lnTo>
                <a:cubicBezTo>
                  <a:pt x="112183" y="600075"/>
                  <a:pt x="111933" y="604058"/>
                  <a:pt x="114300" y="606425"/>
                </a:cubicBezTo>
                <a:cubicBezTo>
                  <a:pt x="116667" y="608792"/>
                  <a:pt x="121040" y="607744"/>
                  <a:pt x="123825" y="609600"/>
                </a:cubicBezTo>
                <a:cubicBezTo>
                  <a:pt x="127561" y="612091"/>
                  <a:pt x="130175" y="615950"/>
                  <a:pt x="133350" y="619125"/>
                </a:cubicBezTo>
                <a:lnTo>
                  <a:pt x="139700" y="638175"/>
                </a:lnTo>
                <a:cubicBezTo>
                  <a:pt x="140758" y="641350"/>
                  <a:pt x="141019" y="644915"/>
                  <a:pt x="142875" y="647700"/>
                </a:cubicBezTo>
                <a:cubicBezTo>
                  <a:pt x="147108" y="654050"/>
                  <a:pt x="153162" y="659510"/>
                  <a:pt x="155575" y="666750"/>
                </a:cubicBezTo>
                <a:cubicBezTo>
                  <a:pt x="156633" y="669925"/>
                  <a:pt x="157253" y="673282"/>
                  <a:pt x="158750" y="676275"/>
                </a:cubicBezTo>
                <a:cubicBezTo>
                  <a:pt x="160457" y="679688"/>
                  <a:pt x="163393" y="682387"/>
                  <a:pt x="165100" y="685800"/>
                </a:cubicBezTo>
                <a:cubicBezTo>
                  <a:pt x="166597" y="688793"/>
                  <a:pt x="166778" y="692332"/>
                  <a:pt x="168275" y="695325"/>
                </a:cubicBezTo>
                <a:cubicBezTo>
                  <a:pt x="169982" y="698738"/>
                  <a:pt x="173075" y="701363"/>
                  <a:pt x="174625" y="704850"/>
                </a:cubicBezTo>
                <a:cubicBezTo>
                  <a:pt x="182888" y="723443"/>
                  <a:pt x="177832" y="727107"/>
                  <a:pt x="193675" y="742950"/>
                </a:cubicBezTo>
                <a:cubicBezTo>
                  <a:pt x="196850" y="746125"/>
                  <a:pt x="199275" y="750294"/>
                  <a:pt x="203200" y="752475"/>
                </a:cubicBezTo>
                <a:cubicBezTo>
                  <a:pt x="209051" y="755726"/>
                  <a:pt x="215900" y="756708"/>
                  <a:pt x="222250" y="758825"/>
                </a:cubicBezTo>
                <a:cubicBezTo>
                  <a:pt x="225425" y="759883"/>
                  <a:pt x="228528" y="761188"/>
                  <a:pt x="231775" y="762000"/>
                </a:cubicBezTo>
                <a:cubicBezTo>
                  <a:pt x="240242" y="764117"/>
                  <a:pt x="248515" y="767268"/>
                  <a:pt x="257175" y="768350"/>
                </a:cubicBezTo>
                <a:cubicBezTo>
                  <a:pt x="277422" y="770881"/>
                  <a:pt x="290564" y="772641"/>
                  <a:pt x="311150" y="774700"/>
                </a:cubicBezTo>
                <a:lnTo>
                  <a:pt x="346075" y="777875"/>
                </a:lnTo>
                <a:lnTo>
                  <a:pt x="374650" y="787400"/>
                </a:lnTo>
                <a:lnTo>
                  <a:pt x="384175" y="790575"/>
                </a:lnTo>
                <a:cubicBezTo>
                  <a:pt x="387350" y="791633"/>
                  <a:pt x="390418" y="793094"/>
                  <a:pt x="393700" y="793750"/>
                </a:cubicBezTo>
                <a:cubicBezTo>
                  <a:pt x="413854" y="797781"/>
                  <a:pt x="404340" y="795616"/>
                  <a:pt x="422275" y="800100"/>
                </a:cubicBezTo>
                <a:cubicBezTo>
                  <a:pt x="455083" y="799042"/>
                  <a:pt x="487928" y="798798"/>
                  <a:pt x="520700" y="796925"/>
                </a:cubicBezTo>
                <a:cubicBezTo>
                  <a:pt x="525057" y="796676"/>
                  <a:pt x="529140" y="794697"/>
                  <a:pt x="533400" y="793750"/>
                </a:cubicBezTo>
                <a:cubicBezTo>
                  <a:pt x="568150" y="786028"/>
                  <a:pt x="534485" y="794695"/>
                  <a:pt x="558800" y="787400"/>
                </a:cubicBezTo>
                <a:cubicBezTo>
                  <a:pt x="566180" y="785186"/>
                  <a:pt x="573645" y="783264"/>
                  <a:pt x="581025" y="781050"/>
                </a:cubicBezTo>
                <a:cubicBezTo>
                  <a:pt x="584231" y="780088"/>
                  <a:pt x="587557" y="779372"/>
                  <a:pt x="590550" y="777875"/>
                </a:cubicBezTo>
                <a:cubicBezTo>
                  <a:pt x="593963" y="776168"/>
                  <a:pt x="596588" y="773075"/>
                  <a:pt x="600075" y="771525"/>
                </a:cubicBezTo>
                <a:cubicBezTo>
                  <a:pt x="606192" y="768807"/>
                  <a:pt x="613556" y="768888"/>
                  <a:pt x="619125" y="765175"/>
                </a:cubicBezTo>
                <a:cubicBezTo>
                  <a:pt x="622300" y="763058"/>
                  <a:pt x="625237" y="760532"/>
                  <a:pt x="628650" y="758825"/>
                </a:cubicBezTo>
                <a:cubicBezTo>
                  <a:pt x="631643" y="757328"/>
                  <a:pt x="635249" y="757275"/>
                  <a:pt x="638175" y="755650"/>
                </a:cubicBezTo>
                <a:cubicBezTo>
                  <a:pt x="644846" y="751944"/>
                  <a:pt x="649985" y="745363"/>
                  <a:pt x="657225" y="742950"/>
                </a:cubicBezTo>
                <a:lnTo>
                  <a:pt x="676275" y="736600"/>
                </a:lnTo>
                <a:lnTo>
                  <a:pt x="685800" y="733425"/>
                </a:lnTo>
                <a:cubicBezTo>
                  <a:pt x="698017" y="715100"/>
                  <a:pt x="684752" y="730774"/>
                  <a:pt x="711200" y="717550"/>
                </a:cubicBezTo>
                <a:cubicBezTo>
                  <a:pt x="715433" y="715433"/>
                  <a:pt x="719886" y="713708"/>
                  <a:pt x="723900" y="711200"/>
                </a:cubicBezTo>
                <a:cubicBezTo>
                  <a:pt x="728387" y="708395"/>
                  <a:pt x="732294" y="704751"/>
                  <a:pt x="736600" y="701675"/>
                </a:cubicBezTo>
                <a:cubicBezTo>
                  <a:pt x="739705" y="699457"/>
                  <a:pt x="743072" y="697615"/>
                  <a:pt x="746125" y="695325"/>
                </a:cubicBezTo>
                <a:cubicBezTo>
                  <a:pt x="751546" y="691259"/>
                  <a:pt x="756519" y="686611"/>
                  <a:pt x="762000" y="682625"/>
                </a:cubicBezTo>
                <a:cubicBezTo>
                  <a:pt x="768172" y="678136"/>
                  <a:pt x="781050" y="669925"/>
                  <a:pt x="781050" y="669925"/>
                </a:cubicBezTo>
                <a:cubicBezTo>
                  <a:pt x="786515" y="661728"/>
                  <a:pt x="796223" y="646402"/>
                  <a:pt x="803275" y="638175"/>
                </a:cubicBezTo>
                <a:cubicBezTo>
                  <a:pt x="806197" y="634766"/>
                  <a:pt x="809625" y="631825"/>
                  <a:pt x="812800" y="628650"/>
                </a:cubicBezTo>
                <a:cubicBezTo>
                  <a:pt x="814917" y="622300"/>
                  <a:pt x="818203" y="616226"/>
                  <a:pt x="819150" y="609600"/>
                </a:cubicBezTo>
                <a:cubicBezTo>
                  <a:pt x="820614" y="599354"/>
                  <a:pt x="822336" y="577834"/>
                  <a:pt x="828675" y="568325"/>
                </a:cubicBezTo>
                <a:lnTo>
                  <a:pt x="835025" y="558800"/>
                </a:lnTo>
                <a:cubicBezTo>
                  <a:pt x="837304" y="549685"/>
                  <a:pt x="840685" y="534780"/>
                  <a:pt x="844550" y="527050"/>
                </a:cubicBezTo>
                <a:cubicBezTo>
                  <a:pt x="848783" y="518583"/>
                  <a:pt x="851570" y="509223"/>
                  <a:pt x="857250" y="501650"/>
                </a:cubicBezTo>
                <a:cubicBezTo>
                  <a:pt x="861597" y="495854"/>
                  <a:pt x="877911" y="474591"/>
                  <a:pt x="879475" y="469900"/>
                </a:cubicBezTo>
                <a:cubicBezTo>
                  <a:pt x="887455" y="445959"/>
                  <a:pt x="876690" y="475469"/>
                  <a:pt x="889000" y="450850"/>
                </a:cubicBezTo>
                <a:cubicBezTo>
                  <a:pt x="890497" y="447857"/>
                  <a:pt x="890857" y="444401"/>
                  <a:pt x="892175" y="441325"/>
                </a:cubicBezTo>
                <a:cubicBezTo>
                  <a:pt x="894039" y="436975"/>
                  <a:pt x="896767" y="433019"/>
                  <a:pt x="898525" y="428625"/>
                </a:cubicBezTo>
                <a:cubicBezTo>
                  <a:pt x="901011" y="422410"/>
                  <a:pt x="902758" y="415925"/>
                  <a:pt x="904875" y="409575"/>
                </a:cubicBezTo>
                <a:lnTo>
                  <a:pt x="911225" y="390525"/>
                </a:lnTo>
                <a:lnTo>
                  <a:pt x="914400" y="381000"/>
                </a:lnTo>
                <a:lnTo>
                  <a:pt x="917575" y="371475"/>
                </a:lnTo>
                <a:cubicBezTo>
                  <a:pt x="913140" y="269462"/>
                  <a:pt x="919406" y="327568"/>
                  <a:pt x="911225" y="282575"/>
                </a:cubicBezTo>
                <a:cubicBezTo>
                  <a:pt x="910585" y="279057"/>
                  <a:pt x="906444" y="252356"/>
                  <a:pt x="904875" y="247650"/>
                </a:cubicBezTo>
                <a:cubicBezTo>
                  <a:pt x="903378" y="243160"/>
                  <a:pt x="900389" y="239300"/>
                  <a:pt x="898525" y="234950"/>
                </a:cubicBezTo>
                <a:cubicBezTo>
                  <a:pt x="897207" y="231874"/>
                  <a:pt x="896847" y="228418"/>
                  <a:pt x="895350" y="225425"/>
                </a:cubicBezTo>
                <a:cubicBezTo>
                  <a:pt x="893643" y="222012"/>
                  <a:pt x="890707" y="219313"/>
                  <a:pt x="889000" y="215900"/>
                </a:cubicBezTo>
                <a:cubicBezTo>
                  <a:pt x="877507" y="192915"/>
                  <a:pt x="897141" y="223106"/>
                  <a:pt x="882650" y="190500"/>
                </a:cubicBezTo>
                <a:cubicBezTo>
                  <a:pt x="880501" y="185664"/>
                  <a:pt x="876300" y="182033"/>
                  <a:pt x="873125" y="177800"/>
                </a:cubicBezTo>
                <a:cubicBezTo>
                  <a:pt x="872067" y="174625"/>
                  <a:pt x="871268" y="171351"/>
                  <a:pt x="869950" y="168275"/>
                </a:cubicBezTo>
                <a:cubicBezTo>
                  <a:pt x="868086" y="163925"/>
                  <a:pt x="865262" y="160007"/>
                  <a:pt x="863600" y="155575"/>
                </a:cubicBezTo>
                <a:cubicBezTo>
                  <a:pt x="862068" y="151489"/>
                  <a:pt x="861957" y="146961"/>
                  <a:pt x="860425" y="142875"/>
                </a:cubicBezTo>
                <a:cubicBezTo>
                  <a:pt x="852076" y="120610"/>
                  <a:pt x="856937" y="139073"/>
                  <a:pt x="847725" y="120650"/>
                </a:cubicBezTo>
                <a:cubicBezTo>
                  <a:pt x="846228" y="117657"/>
                  <a:pt x="846406" y="113910"/>
                  <a:pt x="844550" y="111125"/>
                </a:cubicBezTo>
                <a:cubicBezTo>
                  <a:pt x="818283" y="71725"/>
                  <a:pt x="849450" y="128432"/>
                  <a:pt x="828675" y="92075"/>
                </a:cubicBezTo>
                <a:cubicBezTo>
                  <a:pt x="812522" y="63808"/>
                  <a:pt x="835717" y="95942"/>
                  <a:pt x="806450" y="66675"/>
                </a:cubicBezTo>
                <a:cubicBezTo>
                  <a:pt x="792089" y="52314"/>
                  <a:pt x="809118" y="60156"/>
                  <a:pt x="790575" y="53975"/>
                </a:cubicBezTo>
                <a:cubicBezTo>
                  <a:pt x="779637" y="45771"/>
                  <a:pt x="768651" y="36625"/>
                  <a:pt x="755650" y="31750"/>
                </a:cubicBezTo>
                <a:cubicBezTo>
                  <a:pt x="751564" y="30218"/>
                  <a:pt x="747130" y="29829"/>
                  <a:pt x="742950" y="28575"/>
                </a:cubicBezTo>
                <a:cubicBezTo>
                  <a:pt x="736539" y="26652"/>
                  <a:pt x="730250" y="24342"/>
                  <a:pt x="723900" y="22225"/>
                </a:cubicBezTo>
                <a:cubicBezTo>
                  <a:pt x="720725" y="21167"/>
                  <a:pt x="717696" y="19465"/>
                  <a:pt x="714375" y="19050"/>
                </a:cubicBezTo>
                <a:cubicBezTo>
                  <a:pt x="705908" y="17992"/>
                  <a:pt x="697408" y="17172"/>
                  <a:pt x="688975" y="15875"/>
                </a:cubicBezTo>
                <a:cubicBezTo>
                  <a:pt x="683641" y="15054"/>
                  <a:pt x="678442" y="13463"/>
                  <a:pt x="673100" y="12700"/>
                </a:cubicBezTo>
                <a:cubicBezTo>
                  <a:pt x="663613" y="11345"/>
                  <a:pt x="654035" y="10714"/>
                  <a:pt x="644525" y="9525"/>
                </a:cubicBezTo>
                <a:cubicBezTo>
                  <a:pt x="582518" y="1774"/>
                  <a:pt x="654473" y="10567"/>
                  <a:pt x="606425" y="3175"/>
                </a:cubicBezTo>
                <a:cubicBezTo>
                  <a:pt x="597992" y="1878"/>
                  <a:pt x="589492" y="1058"/>
                  <a:pt x="581025" y="0"/>
                </a:cubicBezTo>
                <a:cubicBezTo>
                  <a:pt x="566208" y="1058"/>
                  <a:pt x="551265" y="971"/>
                  <a:pt x="536575" y="3175"/>
                </a:cubicBezTo>
                <a:cubicBezTo>
                  <a:pt x="529956" y="4168"/>
                  <a:pt x="524019" y="7902"/>
                  <a:pt x="517525" y="9525"/>
                </a:cubicBezTo>
                <a:cubicBezTo>
                  <a:pt x="485631" y="17498"/>
                  <a:pt x="500404" y="13115"/>
                  <a:pt x="473075" y="22225"/>
                </a:cubicBezTo>
                <a:lnTo>
                  <a:pt x="454025" y="28575"/>
                </a:lnTo>
                <a:cubicBezTo>
                  <a:pt x="450850" y="29633"/>
                  <a:pt x="447801" y="31200"/>
                  <a:pt x="444500" y="31750"/>
                </a:cubicBezTo>
                <a:cubicBezTo>
                  <a:pt x="438150" y="32808"/>
                  <a:pt x="431763" y="33662"/>
                  <a:pt x="425450" y="34925"/>
                </a:cubicBezTo>
                <a:cubicBezTo>
                  <a:pt x="421171" y="35781"/>
                  <a:pt x="417087" y="37618"/>
                  <a:pt x="412750" y="38100"/>
                </a:cubicBezTo>
                <a:cubicBezTo>
                  <a:pt x="397986" y="39740"/>
                  <a:pt x="383117" y="40217"/>
                  <a:pt x="368300" y="41275"/>
                </a:cubicBezTo>
                <a:cubicBezTo>
                  <a:pt x="345861" y="45763"/>
                  <a:pt x="357545" y="42743"/>
                  <a:pt x="333375" y="50800"/>
                </a:cubicBezTo>
                <a:cubicBezTo>
                  <a:pt x="330200" y="51858"/>
                  <a:pt x="326635" y="52119"/>
                  <a:pt x="323850" y="53975"/>
                </a:cubicBezTo>
                <a:cubicBezTo>
                  <a:pt x="313080" y="61155"/>
                  <a:pt x="346075" y="56092"/>
                  <a:pt x="339725" y="60325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フリーフォーム 28"/>
          <p:cNvSpPr/>
          <p:nvPr/>
        </p:nvSpPr>
        <p:spPr>
          <a:xfrm>
            <a:off x="5940425" y="1698440"/>
            <a:ext cx="747178" cy="635185"/>
          </a:xfrm>
          <a:custGeom>
            <a:avLst/>
            <a:gdLst>
              <a:gd name="connsiteX0" fmla="*/ 298450 w 747178"/>
              <a:gd name="connsiteY0" fmla="*/ 3360 h 635185"/>
              <a:gd name="connsiteX1" fmla="*/ 152400 w 747178"/>
              <a:gd name="connsiteY1" fmla="*/ 50985 h 635185"/>
              <a:gd name="connsiteX2" fmla="*/ 136525 w 747178"/>
              <a:gd name="connsiteY2" fmla="*/ 57335 h 635185"/>
              <a:gd name="connsiteX3" fmla="*/ 117475 w 747178"/>
              <a:gd name="connsiteY3" fmla="*/ 63685 h 635185"/>
              <a:gd name="connsiteX4" fmla="*/ 98425 w 747178"/>
              <a:gd name="connsiteY4" fmla="*/ 79560 h 635185"/>
              <a:gd name="connsiteX5" fmla="*/ 88900 w 747178"/>
              <a:gd name="connsiteY5" fmla="*/ 85910 h 635185"/>
              <a:gd name="connsiteX6" fmla="*/ 82550 w 747178"/>
              <a:gd name="connsiteY6" fmla="*/ 95435 h 635185"/>
              <a:gd name="connsiteX7" fmla="*/ 73025 w 747178"/>
              <a:gd name="connsiteY7" fmla="*/ 101785 h 635185"/>
              <a:gd name="connsiteX8" fmla="*/ 69850 w 747178"/>
              <a:gd name="connsiteY8" fmla="*/ 111310 h 635185"/>
              <a:gd name="connsiteX9" fmla="*/ 60325 w 747178"/>
              <a:gd name="connsiteY9" fmla="*/ 120835 h 635185"/>
              <a:gd name="connsiteX10" fmla="*/ 50800 w 747178"/>
              <a:gd name="connsiteY10" fmla="*/ 139885 h 635185"/>
              <a:gd name="connsiteX11" fmla="*/ 41275 w 747178"/>
              <a:gd name="connsiteY11" fmla="*/ 149410 h 635185"/>
              <a:gd name="connsiteX12" fmla="*/ 31750 w 747178"/>
              <a:gd name="connsiteY12" fmla="*/ 168460 h 635185"/>
              <a:gd name="connsiteX13" fmla="*/ 28575 w 747178"/>
              <a:gd name="connsiteY13" fmla="*/ 177985 h 635185"/>
              <a:gd name="connsiteX14" fmla="*/ 22225 w 747178"/>
              <a:gd name="connsiteY14" fmla="*/ 187510 h 635185"/>
              <a:gd name="connsiteX15" fmla="*/ 15875 w 747178"/>
              <a:gd name="connsiteY15" fmla="*/ 206560 h 635185"/>
              <a:gd name="connsiteX16" fmla="*/ 9525 w 747178"/>
              <a:gd name="connsiteY16" fmla="*/ 216085 h 635185"/>
              <a:gd name="connsiteX17" fmla="*/ 3175 w 747178"/>
              <a:gd name="connsiteY17" fmla="*/ 244660 h 635185"/>
              <a:gd name="connsiteX18" fmla="*/ 0 w 747178"/>
              <a:gd name="connsiteY18" fmla="*/ 266885 h 635185"/>
              <a:gd name="connsiteX19" fmla="*/ 6350 w 747178"/>
              <a:gd name="connsiteY19" fmla="*/ 327210 h 635185"/>
              <a:gd name="connsiteX20" fmla="*/ 12700 w 747178"/>
              <a:gd name="connsiteY20" fmla="*/ 346260 h 635185"/>
              <a:gd name="connsiteX21" fmla="*/ 25400 w 747178"/>
              <a:gd name="connsiteY21" fmla="*/ 365310 h 635185"/>
              <a:gd name="connsiteX22" fmla="*/ 41275 w 747178"/>
              <a:gd name="connsiteY22" fmla="*/ 393885 h 635185"/>
              <a:gd name="connsiteX23" fmla="*/ 47625 w 747178"/>
              <a:gd name="connsiteY23" fmla="*/ 412935 h 635185"/>
              <a:gd name="connsiteX24" fmla="*/ 50800 w 747178"/>
              <a:gd name="connsiteY24" fmla="*/ 422460 h 635185"/>
              <a:gd name="connsiteX25" fmla="*/ 57150 w 747178"/>
              <a:gd name="connsiteY25" fmla="*/ 431985 h 635185"/>
              <a:gd name="connsiteX26" fmla="*/ 69850 w 747178"/>
              <a:gd name="connsiteY26" fmla="*/ 460560 h 635185"/>
              <a:gd name="connsiteX27" fmla="*/ 73025 w 747178"/>
              <a:gd name="connsiteY27" fmla="*/ 479610 h 635185"/>
              <a:gd name="connsiteX28" fmla="*/ 76200 w 747178"/>
              <a:gd name="connsiteY28" fmla="*/ 511360 h 635185"/>
              <a:gd name="connsiteX29" fmla="*/ 82550 w 747178"/>
              <a:gd name="connsiteY29" fmla="*/ 530410 h 635185"/>
              <a:gd name="connsiteX30" fmla="*/ 92075 w 747178"/>
              <a:gd name="connsiteY30" fmla="*/ 549460 h 635185"/>
              <a:gd name="connsiteX31" fmla="*/ 95250 w 747178"/>
              <a:gd name="connsiteY31" fmla="*/ 562160 h 635185"/>
              <a:gd name="connsiteX32" fmla="*/ 117475 w 747178"/>
              <a:gd name="connsiteY32" fmla="*/ 587560 h 635185"/>
              <a:gd name="connsiteX33" fmla="*/ 123825 w 747178"/>
              <a:gd name="connsiteY33" fmla="*/ 597085 h 635185"/>
              <a:gd name="connsiteX34" fmla="*/ 133350 w 747178"/>
              <a:gd name="connsiteY34" fmla="*/ 600260 h 635185"/>
              <a:gd name="connsiteX35" fmla="*/ 142875 w 747178"/>
              <a:gd name="connsiteY35" fmla="*/ 606610 h 635185"/>
              <a:gd name="connsiteX36" fmla="*/ 161925 w 747178"/>
              <a:gd name="connsiteY36" fmla="*/ 609785 h 635185"/>
              <a:gd name="connsiteX37" fmla="*/ 212725 w 747178"/>
              <a:gd name="connsiteY37" fmla="*/ 616135 h 635185"/>
              <a:gd name="connsiteX38" fmla="*/ 273050 w 747178"/>
              <a:gd name="connsiteY38" fmla="*/ 622485 h 635185"/>
              <a:gd name="connsiteX39" fmla="*/ 295275 w 747178"/>
              <a:gd name="connsiteY39" fmla="*/ 625660 h 635185"/>
              <a:gd name="connsiteX40" fmla="*/ 311150 w 747178"/>
              <a:gd name="connsiteY40" fmla="*/ 628835 h 635185"/>
              <a:gd name="connsiteX41" fmla="*/ 365125 w 747178"/>
              <a:gd name="connsiteY41" fmla="*/ 635185 h 635185"/>
              <a:gd name="connsiteX42" fmla="*/ 457200 w 747178"/>
              <a:gd name="connsiteY42" fmla="*/ 632010 h 635185"/>
              <a:gd name="connsiteX43" fmla="*/ 466725 w 747178"/>
              <a:gd name="connsiteY43" fmla="*/ 628835 h 635185"/>
              <a:gd name="connsiteX44" fmla="*/ 476250 w 747178"/>
              <a:gd name="connsiteY44" fmla="*/ 619310 h 635185"/>
              <a:gd name="connsiteX45" fmla="*/ 479425 w 747178"/>
              <a:gd name="connsiteY45" fmla="*/ 609785 h 635185"/>
              <a:gd name="connsiteX46" fmla="*/ 485775 w 747178"/>
              <a:gd name="connsiteY46" fmla="*/ 600260 h 635185"/>
              <a:gd name="connsiteX47" fmla="*/ 492125 w 747178"/>
              <a:gd name="connsiteY47" fmla="*/ 574860 h 635185"/>
              <a:gd name="connsiteX48" fmla="*/ 520700 w 747178"/>
              <a:gd name="connsiteY48" fmla="*/ 562160 h 635185"/>
              <a:gd name="connsiteX49" fmla="*/ 530225 w 747178"/>
              <a:gd name="connsiteY49" fmla="*/ 555810 h 635185"/>
              <a:gd name="connsiteX50" fmla="*/ 549275 w 747178"/>
              <a:gd name="connsiteY50" fmla="*/ 549460 h 635185"/>
              <a:gd name="connsiteX51" fmla="*/ 558800 w 747178"/>
              <a:gd name="connsiteY51" fmla="*/ 546285 h 635185"/>
              <a:gd name="connsiteX52" fmla="*/ 568325 w 747178"/>
              <a:gd name="connsiteY52" fmla="*/ 543110 h 635185"/>
              <a:gd name="connsiteX53" fmla="*/ 581025 w 747178"/>
              <a:gd name="connsiteY53" fmla="*/ 539935 h 635185"/>
              <a:gd name="connsiteX54" fmla="*/ 609600 w 747178"/>
              <a:gd name="connsiteY54" fmla="*/ 530410 h 635185"/>
              <a:gd name="connsiteX55" fmla="*/ 619125 w 747178"/>
              <a:gd name="connsiteY55" fmla="*/ 527235 h 635185"/>
              <a:gd name="connsiteX56" fmla="*/ 650875 w 747178"/>
              <a:gd name="connsiteY56" fmla="*/ 514535 h 635185"/>
              <a:gd name="connsiteX57" fmla="*/ 666750 w 747178"/>
              <a:gd name="connsiteY57" fmla="*/ 505010 h 635185"/>
              <a:gd name="connsiteX58" fmla="*/ 679450 w 747178"/>
              <a:gd name="connsiteY58" fmla="*/ 498660 h 635185"/>
              <a:gd name="connsiteX59" fmla="*/ 688975 w 747178"/>
              <a:gd name="connsiteY59" fmla="*/ 485960 h 635185"/>
              <a:gd name="connsiteX60" fmla="*/ 698500 w 747178"/>
              <a:gd name="connsiteY60" fmla="*/ 476435 h 635185"/>
              <a:gd name="connsiteX61" fmla="*/ 708025 w 747178"/>
              <a:gd name="connsiteY61" fmla="*/ 460560 h 635185"/>
              <a:gd name="connsiteX62" fmla="*/ 720725 w 747178"/>
              <a:gd name="connsiteY62" fmla="*/ 444685 h 635185"/>
              <a:gd name="connsiteX63" fmla="*/ 723900 w 747178"/>
              <a:gd name="connsiteY63" fmla="*/ 435160 h 635185"/>
              <a:gd name="connsiteX64" fmla="*/ 736600 w 747178"/>
              <a:gd name="connsiteY64" fmla="*/ 416110 h 635185"/>
              <a:gd name="connsiteX65" fmla="*/ 739775 w 747178"/>
              <a:gd name="connsiteY65" fmla="*/ 400235 h 635185"/>
              <a:gd name="connsiteX66" fmla="*/ 742950 w 747178"/>
              <a:gd name="connsiteY66" fmla="*/ 390710 h 635185"/>
              <a:gd name="connsiteX67" fmla="*/ 742950 w 747178"/>
              <a:gd name="connsiteY67" fmla="*/ 298635 h 635185"/>
              <a:gd name="connsiteX68" fmla="*/ 736600 w 747178"/>
              <a:gd name="connsiteY68" fmla="*/ 285935 h 635185"/>
              <a:gd name="connsiteX69" fmla="*/ 723900 w 747178"/>
              <a:gd name="connsiteY69" fmla="*/ 260535 h 635185"/>
              <a:gd name="connsiteX70" fmla="*/ 711200 w 747178"/>
              <a:gd name="connsiteY70" fmla="*/ 251010 h 635185"/>
              <a:gd name="connsiteX71" fmla="*/ 698500 w 747178"/>
              <a:gd name="connsiteY71" fmla="*/ 228785 h 635185"/>
              <a:gd name="connsiteX72" fmla="*/ 692150 w 747178"/>
              <a:gd name="connsiteY72" fmla="*/ 219260 h 635185"/>
              <a:gd name="connsiteX73" fmla="*/ 666750 w 747178"/>
              <a:gd name="connsiteY73" fmla="*/ 193860 h 635185"/>
              <a:gd name="connsiteX74" fmla="*/ 657225 w 747178"/>
              <a:gd name="connsiteY74" fmla="*/ 174810 h 635185"/>
              <a:gd name="connsiteX75" fmla="*/ 647700 w 747178"/>
              <a:gd name="connsiteY75" fmla="*/ 168460 h 635185"/>
              <a:gd name="connsiteX76" fmla="*/ 628650 w 747178"/>
              <a:gd name="connsiteY76" fmla="*/ 146235 h 635185"/>
              <a:gd name="connsiteX77" fmla="*/ 622300 w 747178"/>
              <a:gd name="connsiteY77" fmla="*/ 136710 h 635185"/>
              <a:gd name="connsiteX78" fmla="*/ 587375 w 747178"/>
              <a:gd name="connsiteY78" fmla="*/ 114485 h 635185"/>
              <a:gd name="connsiteX79" fmla="*/ 568325 w 747178"/>
              <a:gd name="connsiteY79" fmla="*/ 101785 h 635185"/>
              <a:gd name="connsiteX80" fmla="*/ 555625 w 747178"/>
              <a:gd name="connsiteY80" fmla="*/ 92260 h 635185"/>
              <a:gd name="connsiteX81" fmla="*/ 542925 w 747178"/>
              <a:gd name="connsiteY81" fmla="*/ 85910 h 635185"/>
              <a:gd name="connsiteX82" fmla="*/ 533400 w 747178"/>
              <a:gd name="connsiteY82" fmla="*/ 79560 h 635185"/>
              <a:gd name="connsiteX83" fmla="*/ 523875 w 747178"/>
              <a:gd name="connsiteY83" fmla="*/ 76385 h 635185"/>
              <a:gd name="connsiteX84" fmla="*/ 501650 w 747178"/>
              <a:gd name="connsiteY84" fmla="*/ 60510 h 635185"/>
              <a:gd name="connsiteX85" fmla="*/ 485775 w 747178"/>
              <a:gd name="connsiteY85" fmla="*/ 54160 h 635185"/>
              <a:gd name="connsiteX86" fmla="*/ 457200 w 747178"/>
              <a:gd name="connsiteY86" fmla="*/ 38285 h 635185"/>
              <a:gd name="connsiteX87" fmla="*/ 447675 w 747178"/>
              <a:gd name="connsiteY87" fmla="*/ 35110 h 635185"/>
              <a:gd name="connsiteX88" fmla="*/ 422275 w 747178"/>
              <a:gd name="connsiteY88" fmla="*/ 19235 h 635185"/>
              <a:gd name="connsiteX89" fmla="*/ 400050 w 747178"/>
              <a:gd name="connsiteY89" fmla="*/ 9710 h 635185"/>
              <a:gd name="connsiteX90" fmla="*/ 381000 w 747178"/>
              <a:gd name="connsiteY90" fmla="*/ 3360 h 635185"/>
              <a:gd name="connsiteX91" fmla="*/ 371475 w 747178"/>
              <a:gd name="connsiteY91" fmla="*/ 185 h 635185"/>
              <a:gd name="connsiteX92" fmla="*/ 295275 w 747178"/>
              <a:gd name="connsiteY92" fmla="*/ 3360 h 635185"/>
              <a:gd name="connsiteX93" fmla="*/ 298450 w 747178"/>
              <a:gd name="connsiteY93" fmla="*/ 3360 h 6351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</a:cxnLst>
            <a:rect l="l" t="t" r="r" b="b"/>
            <a:pathLst>
              <a:path w="747178" h="635185">
                <a:moveTo>
                  <a:pt x="298450" y="3360"/>
                </a:moveTo>
                <a:lnTo>
                  <a:pt x="152400" y="50985"/>
                </a:lnTo>
                <a:cubicBezTo>
                  <a:pt x="146993" y="52787"/>
                  <a:pt x="141881" y="55387"/>
                  <a:pt x="136525" y="57335"/>
                </a:cubicBezTo>
                <a:cubicBezTo>
                  <a:pt x="130235" y="59622"/>
                  <a:pt x="123044" y="59972"/>
                  <a:pt x="117475" y="63685"/>
                </a:cubicBezTo>
                <a:cubicBezTo>
                  <a:pt x="93826" y="79451"/>
                  <a:pt x="122871" y="59188"/>
                  <a:pt x="98425" y="79560"/>
                </a:cubicBezTo>
                <a:cubicBezTo>
                  <a:pt x="95494" y="82003"/>
                  <a:pt x="92075" y="83793"/>
                  <a:pt x="88900" y="85910"/>
                </a:cubicBezTo>
                <a:cubicBezTo>
                  <a:pt x="86783" y="89085"/>
                  <a:pt x="85248" y="92737"/>
                  <a:pt x="82550" y="95435"/>
                </a:cubicBezTo>
                <a:cubicBezTo>
                  <a:pt x="79852" y="98133"/>
                  <a:pt x="75409" y="98805"/>
                  <a:pt x="73025" y="101785"/>
                </a:cubicBezTo>
                <a:cubicBezTo>
                  <a:pt x="70934" y="104398"/>
                  <a:pt x="71706" y="108525"/>
                  <a:pt x="69850" y="111310"/>
                </a:cubicBezTo>
                <a:cubicBezTo>
                  <a:pt x="67359" y="115046"/>
                  <a:pt x="63200" y="117386"/>
                  <a:pt x="60325" y="120835"/>
                </a:cubicBezTo>
                <a:cubicBezTo>
                  <a:pt x="35346" y="150810"/>
                  <a:pt x="69893" y="111246"/>
                  <a:pt x="50800" y="139885"/>
                </a:cubicBezTo>
                <a:cubicBezTo>
                  <a:pt x="48309" y="143621"/>
                  <a:pt x="44450" y="146235"/>
                  <a:pt x="41275" y="149410"/>
                </a:cubicBezTo>
                <a:cubicBezTo>
                  <a:pt x="33295" y="173351"/>
                  <a:pt x="44060" y="143841"/>
                  <a:pt x="31750" y="168460"/>
                </a:cubicBezTo>
                <a:cubicBezTo>
                  <a:pt x="30253" y="171453"/>
                  <a:pt x="30072" y="174992"/>
                  <a:pt x="28575" y="177985"/>
                </a:cubicBezTo>
                <a:cubicBezTo>
                  <a:pt x="26868" y="181398"/>
                  <a:pt x="23775" y="184023"/>
                  <a:pt x="22225" y="187510"/>
                </a:cubicBezTo>
                <a:cubicBezTo>
                  <a:pt x="19507" y="193627"/>
                  <a:pt x="19588" y="200991"/>
                  <a:pt x="15875" y="206560"/>
                </a:cubicBezTo>
                <a:cubicBezTo>
                  <a:pt x="13758" y="209735"/>
                  <a:pt x="11232" y="212672"/>
                  <a:pt x="9525" y="216085"/>
                </a:cubicBezTo>
                <a:cubicBezTo>
                  <a:pt x="5687" y="223760"/>
                  <a:pt x="4259" y="237614"/>
                  <a:pt x="3175" y="244660"/>
                </a:cubicBezTo>
                <a:cubicBezTo>
                  <a:pt x="2037" y="252057"/>
                  <a:pt x="1058" y="259477"/>
                  <a:pt x="0" y="266885"/>
                </a:cubicBezTo>
                <a:cubicBezTo>
                  <a:pt x="1076" y="280870"/>
                  <a:pt x="2116" y="310275"/>
                  <a:pt x="6350" y="327210"/>
                </a:cubicBezTo>
                <a:cubicBezTo>
                  <a:pt x="7973" y="333704"/>
                  <a:pt x="8987" y="340691"/>
                  <a:pt x="12700" y="346260"/>
                </a:cubicBezTo>
                <a:cubicBezTo>
                  <a:pt x="16933" y="352610"/>
                  <a:pt x="22987" y="358070"/>
                  <a:pt x="25400" y="365310"/>
                </a:cubicBezTo>
                <a:cubicBezTo>
                  <a:pt x="33170" y="388620"/>
                  <a:pt x="27017" y="379627"/>
                  <a:pt x="41275" y="393885"/>
                </a:cubicBezTo>
                <a:lnTo>
                  <a:pt x="47625" y="412935"/>
                </a:lnTo>
                <a:cubicBezTo>
                  <a:pt x="48683" y="416110"/>
                  <a:pt x="48944" y="419675"/>
                  <a:pt x="50800" y="422460"/>
                </a:cubicBezTo>
                <a:cubicBezTo>
                  <a:pt x="52917" y="425635"/>
                  <a:pt x="55600" y="428498"/>
                  <a:pt x="57150" y="431985"/>
                </a:cubicBezTo>
                <a:cubicBezTo>
                  <a:pt x="72263" y="465990"/>
                  <a:pt x="55479" y="439004"/>
                  <a:pt x="69850" y="460560"/>
                </a:cubicBezTo>
                <a:cubicBezTo>
                  <a:pt x="70908" y="466910"/>
                  <a:pt x="72227" y="473222"/>
                  <a:pt x="73025" y="479610"/>
                </a:cubicBezTo>
                <a:cubicBezTo>
                  <a:pt x="74344" y="490164"/>
                  <a:pt x="74240" y="500906"/>
                  <a:pt x="76200" y="511360"/>
                </a:cubicBezTo>
                <a:cubicBezTo>
                  <a:pt x="77434" y="517939"/>
                  <a:pt x="80433" y="524060"/>
                  <a:pt x="82550" y="530410"/>
                </a:cubicBezTo>
                <a:cubicBezTo>
                  <a:pt x="86932" y="543555"/>
                  <a:pt x="83869" y="537150"/>
                  <a:pt x="92075" y="549460"/>
                </a:cubicBezTo>
                <a:cubicBezTo>
                  <a:pt x="93133" y="553693"/>
                  <a:pt x="93299" y="558257"/>
                  <a:pt x="95250" y="562160"/>
                </a:cubicBezTo>
                <a:cubicBezTo>
                  <a:pt x="104510" y="580681"/>
                  <a:pt x="104378" y="578829"/>
                  <a:pt x="117475" y="587560"/>
                </a:cubicBezTo>
                <a:cubicBezTo>
                  <a:pt x="119592" y="590735"/>
                  <a:pt x="120845" y="594701"/>
                  <a:pt x="123825" y="597085"/>
                </a:cubicBezTo>
                <a:cubicBezTo>
                  <a:pt x="126438" y="599176"/>
                  <a:pt x="130357" y="598763"/>
                  <a:pt x="133350" y="600260"/>
                </a:cubicBezTo>
                <a:cubicBezTo>
                  <a:pt x="136763" y="601967"/>
                  <a:pt x="139255" y="605403"/>
                  <a:pt x="142875" y="606610"/>
                </a:cubicBezTo>
                <a:cubicBezTo>
                  <a:pt x="148982" y="608646"/>
                  <a:pt x="155591" y="608633"/>
                  <a:pt x="161925" y="609785"/>
                </a:cubicBezTo>
                <a:cubicBezTo>
                  <a:pt x="195934" y="615968"/>
                  <a:pt x="157975" y="610921"/>
                  <a:pt x="212725" y="616135"/>
                </a:cubicBezTo>
                <a:cubicBezTo>
                  <a:pt x="227131" y="617507"/>
                  <a:pt x="258124" y="620619"/>
                  <a:pt x="273050" y="622485"/>
                </a:cubicBezTo>
                <a:cubicBezTo>
                  <a:pt x="280476" y="623413"/>
                  <a:pt x="287893" y="624430"/>
                  <a:pt x="295275" y="625660"/>
                </a:cubicBezTo>
                <a:cubicBezTo>
                  <a:pt x="300598" y="626547"/>
                  <a:pt x="305795" y="628166"/>
                  <a:pt x="311150" y="628835"/>
                </a:cubicBezTo>
                <a:cubicBezTo>
                  <a:pt x="386307" y="638230"/>
                  <a:pt x="315919" y="626984"/>
                  <a:pt x="365125" y="635185"/>
                </a:cubicBezTo>
                <a:cubicBezTo>
                  <a:pt x="395817" y="634127"/>
                  <a:pt x="426550" y="633926"/>
                  <a:pt x="457200" y="632010"/>
                </a:cubicBezTo>
                <a:cubicBezTo>
                  <a:pt x="460540" y="631801"/>
                  <a:pt x="463940" y="630691"/>
                  <a:pt x="466725" y="628835"/>
                </a:cubicBezTo>
                <a:cubicBezTo>
                  <a:pt x="470461" y="626344"/>
                  <a:pt x="473075" y="622485"/>
                  <a:pt x="476250" y="619310"/>
                </a:cubicBezTo>
                <a:cubicBezTo>
                  <a:pt x="477308" y="616135"/>
                  <a:pt x="477928" y="612778"/>
                  <a:pt x="479425" y="609785"/>
                </a:cubicBezTo>
                <a:cubicBezTo>
                  <a:pt x="481132" y="606372"/>
                  <a:pt x="484435" y="603833"/>
                  <a:pt x="485775" y="600260"/>
                </a:cubicBezTo>
                <a:cubicBezTo>
                  <a:pt x="486194" y="599144"/>
                  <a:pt x="489360" y="578316"/>
                  <a:pt x="492125" y="574860"/>
                </a:cubicBezTo>
                <a:cubicBezTo>
                  <a:pt x="499510" y="565629"/>
                  <a:pt x="511553" y="568258"/>
                  <a:pt x="520700" y="562160"/>
                </a:cubicBezTo>
                <a:cubicBezTo>
                  <a:pt x="523875" y="560043"/>
                  <a:pt x="526738" y="557360"/>
                  <a:pt x="530225" y="555810"/>
                </a:cubicBezTo>
                <a:cubicBezTo>
                  <a:pt x="536342" y="553092"/>
                  <a:pt x="542925" y="551577"/>
                  <a:pt x="549275" y="549460"/>
                </a:cubicBezTo>
                <a:lnTo>
                  <a:pt x="558800" y="546285"/>
                </a:lnTo>
                <a:cubicBezTo>
                  <a:pt x="561975" y="545227"/>
                  <a:pt x="565078" y="543922"/>
                  <a:pt x="568325" y="543110"/>
                </a:cubicBezTo>
                <a:cubicBezTo>
                  <a:pt x="572558" y="542052"/>
                  <a:pt x="576845" y="541189"/>
                  <a:pt x="581025" y="539935"/>
                </a:cubicBezTo>
                <a:cubicBezTo>
                  <a:pt x="590642" y="537050"/>
                  <a:pt x="600075" y="533585"/>
                  <a:pt x="609600" y="530410"/>
                </a:cubicBezTo>
                <a:cubicBezTo>
                  <a:pt x="612775" y="529352"/>
                  <a:pt x="616340" y="529091"/>
                  <a:pt x="619125" y="527235"/>
                </a:cubicBezTo>
                <a:cubicBezTo>
                  <a:pt x="635061" y="516611"/>
                  <a:pt x="624981" y="521933"/>
                  <a:pt x="650875" y="514535"/>
                </a:cubicBezTo>
                <a:cubicBezTo>
                  <a:pt x="656167" y="511360"/>
                  <a:pt x="661355" y="508007"/>
                  <a:pt x="666750" y="505010"/>
                </a:cubicBezTo>
                <a:cubicBezTo>
                  <a:pt x="670887" y="502711"/>
                  <a:pt x="675856" y="501740"/>
                  <a:pt x="679450" y="498660"/>
                </a:cubicBezTo>
                <a:cubicBezTo>
                  <a:pt x="683468" y="495216"/>
                  <a:pt x="685531" y="489978"/>
                  <a:pt x="688975" y="485960"/>
                </a:cubicBezTo>
                <a:cubicBezTo>
                  <a:pt x="691897" y="482551"/>
                  <a:pt x="695806" y="480027"/>
                  <a:pt x="698500" y="476435"/>
                </a:cubicBezTo>
                <a:cubicBezTo>
                  <a:pt x="702203" y="471498"/>
                  <a:pt x="704486" y="465616"/>
                  <a:pt x="708025" y="460560"/>
                </a:cubicBezTo>
                <a:cubicBezTo>
                  <a:pt x="711911" y="455008"/>
                  <a:pt x="716492" y="449977"/>
                  <a:pt x="720725" y="444685"/>
                </a:cubicBezTo>
                <a:cubicBezTo>
                  <a:pt x="721783" y="441510"/>
                  <a:pt x="722275" y="438086"/>
                  <a:pt x="723900" y="435160"/>
                </a:cubicBezTo>
                <a:cubicBezTo>
                  <a:pt x="727606" y="428489"/>
                  <a:pt x="733442" y="423058"/>
                  <a:pt x="736600" y="416110"/>
                </a:cubicBezTo>
                <a:cubicBezTo>
                  <a:pt x="738833" y="411197"/>
                  <a:pt x="738466" y="405470"/>
                  <a:pt x="739775" y="400235"/>
                </a:cubicBezTo>
                <a:cubicBezTo>
                  <a:pt x="740587" y="396988"/>
                  <a:pt x="741892" y="393885"/>
                  <a:pt x="742950" y="390710"/>
                </a:cubicBezTo>
                <a:cubicBezTo>
                  <a:pt x="747820" y="351751"/>
                  <a:pt x="749308" y="351617"/>
                  <a:pt x="742950" y="298635"/>
                </a:cubicBezTo>
                <a:cubicBezTo>
                  <a:pt x="742386" y="293936"/>
                  <a:pt x="738522" y="290260"/>
                  <a:pt x="736600" y="285935"/>
                </a:cubicBezTo>
                <a:cubicBezTo>
                  <a:pt x="732962" y="277749"/>
                  <a:pt x="730647" y="267282"/>
                  <a:pt x="723900" y="260535"/>
                </a:cubicBezTo>
                <a:cubicBezTo>
                  <a:pt x="720158" y="256793"/>
                  <a:pt x="715433" y="254185"/>
                  <a:pt x="711200" y="251010"/>
                </a:cubicBezTo>
                <a:cubicBezTo>
                  <a:pt x="706048" y="235553"/>
                  <a:pt x="710514" y="245604"/>
                  <a:pt x="698500" y="228785"/>
                </a:cubicBezTo>
                <a:cubicBezTo>
                  <a:pt x="696282" y="225680"/>
                  <a:pt x="694717" y="222084"/>
                  <a:pt x="692150" y="219260"/>
                </a:cubicBezTo>
                <a:cubicBezTo>
                  <a:pt x="684096" y="210400"/>
                  <a:pt x="666750" y="193860"/>
                  <a:pt x="666750" y="193860"/>
                </a:cubicBezTo>
                <a:cubicBezTo>
                  <a:pt x="664168" y="186113"/>
                  <a:pt x="663380" y="180965"/>
                  <a:pt x="657225" y="174810"/>
                </a:cubicBezTo>
                <a:cubicBezTo>
                  <a:pt x="654527" y="172112"/>
                  <a:pt x="650875" y="170577"/>
                  <a:pt x="647700" y="168460"/>
                </a:cubicBezTo>
                <a:cubicBezTo>
                  <a:pt x="624358" y="129556"/>
                  <a:pt x="650639" y="168224"/>
                  <a:pt x="628650" y="146235"/>
                </a:cubicBezTo>
                <a:cubicBezTo>
                  <a:pt x="625952" y="143537"/>
                  <a:pt x="625136" y="139263"/>
                  <a:pt x="622300" y="136710"/>
                </a:cubicBezTo>
                <a:cubicBezTo>
                  <a:pt x="601655" y="118129"/>
                  <a:pt x="604590" y="120223"/>
                  <a:pt x="587375" y="114485"/>
                </a:cubicBezTo>
                <a:cubicBezTo>
                  <a:pt x="565209" y="92319"/>
                  <a:pt x="589768" y="114038"/>
                  <a:pt x="568325" y="101785"/>
                </a:cubicBezTo>
                <a:cubicBezTo>
                  <a:pt x="563731" y="99160"/>
                  <a:pt x="560112" y="95065"/>
                  <a:pt x="555625" y="92260"/>
                </a:cubicBezTo>
                <a:cubicBezTo>
                  <a:pt x="551611" y="89752"/>
                  <a:pt x="547034" y="88258"/>
                  <a:pt x="542925" y="85910"/>
                </a:cubicBezTo>
                <a:cubicBezTo>
                  <a:pt x="539612" y="84017"/>
                  <a:pt x="536813" y="81267"/>
                  <a:pt x="533400" y="79560"/>
                </a:cubicBezTo>
                <a:cubicBezTo>
                  <a:pt x="530407" y="78063"/>
                  <a:pt x="526868" y="77882"/>
                  <a:pt x="523875" y="76385"/>
                </a:cubicBezTo>
                <a:cubicBezTo>
                  <a:pt x="511973" y="70434"/>
                  <a:pt x="514593" y="67701"/>
                  <a:pt x="501650" y="60510"/>
                </a:cubicBezTo>
                <a:cubicBezTo>
                  <a:pt x="496668" y="57742"/>
                  <a:pt x="490873" y="56709"/>
                  <a:pt x="485775" y="54160"/>
                </a:cubicBezTo>
                <a:cubicBezTo>
                  <a:pt x="461690" y="42117"/>
                  <a:pt x="478604" y="47458"/>
                  <a:pt x="457200" y="38285"/>
                </a:cubicBezTo>
                <a:cubicBezTo>
                  <a:pt x="454124" y="36967"/>
                  <a:pt x="450613" y="36713"/>
                  <a:pt x="447675" y="35110"/>
                </a:cubicBezTo>
                <a:cubicBezTo>
                  <a:pt x="438910" y="30329"/>
                  <a:pt x="431747" y="22392"/>
                  <a:pt x="422275" y="19235"/>
                </a:cubicBezTo>
                <a:cubicBezTo>
                  <a:pt x="391614" y="9015"/>
                  <a:pt x="439284" y="25403"/>
                  <a:pt x="400050" y="9710"/>
                </a:cubicBezTo>
                <a:cubicBezTo>
                  <a:pt x="393835" y="7224"/>
                  <a:pt x="387350" y="5477"/>
                  <a:pt x="381000" y="3360"/>
                </a:cubicBezTo>
                <a:lnTo>
                  <a:pt x="371475" y="185"/>
                </a:lnTo>
                <a:cubicBezTo>
                  <a:pt x="346075" y="1243"/>
                  <a:pt x="320628" y="1482"/>
                  <a:pt x="295275" y="3360"/>
                </a:cubicBezTo>
                <a:cubicBezTo>
                  <a:pt x="284746" y="4140"/>
                  <a:pt x="322263" y="-4578"/>
                  <a:pt x="298450" y="336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2" name="フリーフォーム 121"/>
          <p:cNvSpPr/>
          <p:nvPr/>
        </p:nvSpPr>
        <p:spPr>
          <a:xfrm>
            <a:off x="5942961" y="4627267"/>
            <a:ext cx="747178" cy="635185"/>
          </a:xfrm>
          <a:custGeom>
            <a:avLst/>
            <a:gdLst>
              <a:gd name="connsiteX0" fmla="*/ 298450 w 747178"/>
              <a:gd name="connsiteY0" fmla="*/ 3360 h 635185"/>
              <a:gd name="connsiteX1" fmla="*/ 152400 w 747178"/>
              <a:gd name="connsiteY1" fmla="*/ 50985 h 635185"/>
              <a:gd name="connsiteX2" fmla="*/ 136525 w 747178"/>
              <a:gd name="connsiteY2" fmla="*/ 57335 h 635185"/>
              <a:gd name="connsiteX3" fmla="*/ 117475 w 747178"/>
              <a:gd name="connsiteY3" fmla="*/ 63685 h 635185"/>
              <a:gd name="connsiteX4" fmla="*/ 98425 w 747178"/>
              <a:gd name="connsiteY4" fmla="*/ 79560 h 635185"/>
              <a:gd name="connsiteX5" fmla="*/ 88900 w 747178"/>
              <a:gd name="connsiteY5" fmla="*/ 85910 h 635185"/>
              <a:gd name="connsiteX6" fmla="*/ 82550 w 747178"/>
              <a:gd name="connsiteY6" fmla="*/ 95435 h 635185"/>
              <a:gd name="connsiteX7" fmla="*/ 73025 w 747178"/>
              <a:gd name="connsiteY7" fmla="*/ 101785 h 635185"/>
              <a:gd name="connsiteX8" fmla="*/ 69850 w 747178"/>
              <a:gd name="connsiteY8" fmla="*/ 111310 h 635185"/>
              <a:gd name="connsiteX9" fmla="*/ 60325 w 747178"/>
              <a:gd name="connsiteY9" fmla="*/ 120835 h 635185"/>
              <a:gd name="connsiteX10" fmla="*/ 50800 w 747178"/>
              <a:gd name="connsiteY10" fmla="*/ 139885 h 635185"/>
              <a:gd name="connsiteX11" fmla="*/ 41275 w 747178"/>
              <a:gd name="connsiteY11" fmla="*/ 149410 h 635185"/>
              <a:gd name="connsiteX12" fmla="*/ 31750 w 747178"/>
              <a:gd name="connsiteY12" fmla="*/ 168460 h 635185"/>
              <a:gd name="connsiteX13" fmla="*/ 28575 w 747178"/>
              <a:gd name="connsiteY13" fmla="*/ 177985 h 635185"/>
              <a:gd name="connsiteX14" fmla="*/ 22225 w 747178"/>
              <a:gd name="connsiteY14" fmla="*/ 187510 h 635185"/>
              <a:gd name="connsiteX15" fmla="*/ 15875 w 747178"/>
              <a:gd name="connsiteY15" fmla="*/ 206560 h 635185"/>
              <a:gd name="connsiteX16" fmla="*/ 9525 w 747178"/>
              <a:gd name="connsiteY16" fmla="*/ 216085 h 635185"/>
              <a:gd name="connsiteX17" fmla="*/ 3175 w 747178"/>
              <a:gd name="connsiteY17" fmla="*/ 244660 h 635185"/>
              <a:gd name="connsiteX18" fmla="*/ 0 w 747178"/>
              <a:gd name="connsiteY18" fmla="*/ 266885 h 635185"/>
              <a:gd name="connsiteX19" fmla="*/ 6350 w 747178"/>
              <a:gd name="connsiteY19" fmla="*/ 327210 h 635185"/>
              <a:gd name="connsiteX20" fmla="*/ 12700 w 747178"/>
              <a:gd name="connsiteY20" fmla="*/ 346260 h 635185"/>
              <a:gd name="connsiteX21" fmla="*/ 25400 w 747178"/>
              <a:gd name="connsiteY21" fmla="*/ 365310 h 635185"/>
              <a:gd name="connsiteX22" fmla="*/ 41275 w 747178"/>
              <a:gd name="connsiteY22" fmla="*/ 393885 h 635185"/>
              <a:gd name="connsiteX23" fmla="*/ 47625 w 747178"/>
              <a:gd name="connsiteY23" fmla="*/ 412935 h 635185"/>
              <a:gd name="connsiteX24" fmla="*/ 50800 w 747178"/>
              <a:gd name="connsiteY24" fmla="*/ 422460 h 635185"/>
              <a:gd name="connsiteX25" fmla="*/ 57150 w 747178"/>
              <a:gd name="connsiteY25" fmla="*/ 431985 h 635185"/>
              <a:gd name="connsiteX26" fmla="*/ 69850 w 747178"/>
              <a:gd name="connsiteY26" fmla="*/ 460560 h 635185"/>
              <a:gd name="connsiteX27" fmla="*/ 73025 w 747178"/>
              <a:gd name="connsiteY27" fmla="*/ 479610 h 635185"/>
              <a:gd name="connsiteX28" fmla="*/ 76200 w 747178"/>
              <a:gd name="connsiteY28" fmla="*/ 511360 h 635185"/>
              <a:gd name="connsiteX29" fmla="*/ 82550 w 747178"/>
              <a:gd name="connsiteY29" fmla="*/ 530410 h 635185"/>
              <a:gd name="connsiteX30" fmla="*/ 92075 w 747178"/>
              <a:gd name="connsiteY30" fmla="*/ 549460 h 635185"/>
              <a:gd name="connsiteX31" fmla="*/ 95250 w 747178"/>
              <a:gd name="connsiteY31" fmla="*/ 562160 h 635185"/>
              <a:gd name="connsiteX32" fmla="*/ 117475 w 747178"/>
              <a:gd name="connsiteY32" fmla="*/ 587560 h 635185"/>
              <a:gd name="connsiteX33" fmla="*/ 123825 w 747178"/>
              <a:gd name="connsiteY33" fmla="*/ 597085 h 635185"/>
              <a:gd name="connsiteX34" fmla="*/ 133350 w 747178"/>
              <a:gd name="connsiteY34" fmla="*/ 600260 h 635185"/>
              <a:gd name="connsiteX35" fmla="*/ 142875 w 747178"/>
              <a:gd name="connsiteY35" fmla="*/ 606610 h 635185"/>
              <a:gd name="connsiteX36" fmla="*/ 161925 w 747178"/>
              <a:gd name="connsiteY36" fmla="*/ 609785 h 635185"/>
              <a:gd name="connsiteX37" fmla="*/ 212725 w 747178"/>
              <a:gd name="connsiteY37" fmla="*/ 616135 h 635185"/>
              <a:gd name="connsiteX38" fmla="*/ 273050 w 747178"/>
              <a:gd name="connsiteY38" fmla="*/ 622485 h 635185"/>
              <a:gd name="connsiteX39" fmla="*/ 295275 w 747178"/>
              <a:gd name="connsiteY39" fmla="*/ 625660 h 635185"/>
              <a:gd name="connsiteX40" fmla="*/ 311150 w 747178"/>
              <a:gd name="connsiteY40" fmla="*/ 628835 h 635185"/>
              <a:gd name="connsiteX41" fmla="*/ 365125 w 747178"/>
              <a:gd name="connsiteY41" fmla="*/ 635185 h 635185"/>
              <a:gd name="connsiteX42" fmla="*/ 457200 w 747178"/>
              <a:gd name="connsiteY42" fmla="*/ 632010 h 635185"/>
              <a:gd name="connsiteX43" fmla="*/ 466725 w 747178"/>
              <a:gd name="connsiteY43" fmla="*/ 628835 h 635185"/>
              <a:gd name="connsiteX44" fmla="*/ 476250 w 747178"/>
              <a:gd name="connsiteY44" fmla="*/ 619310 h 635185"/>
              <a:gd name="connsiteX45" fmla="*/ 479425 w 747178"/>
              <a:gd name="connsiteY45" fmla="*/ 609785 h 635185"/>
              <a:gd name="connsiteX46" fmla="*/ 485775 w 747178"/>
              <a:gd name="connsiteY46" fmla="*/ 600260 h 635185"/>
              <a:gd name="connsiteX47" fmla="*/ 492125 w 747178"/>
              <a:gd name="connsiteY47" fmla="*/ 574860 h 635185"/>
              <a:gd name="connsiteX48" fmla="*/ 520700 w 747178"/>
              <a:gd name="connsiteY48" fmla="*/ 562160 h 635185"/>
              <a:gd name="connsiteX49" fmla="*/ 530225 w 747178"/>
              <a:gd name="connsiteY49" fmla="*/ 555810 h 635185"/>
              <a:gd name="connsiteX50" fmla="*/ 549275 w 747178"/>
              <a:gd name="connsiteY50" fmla="*/ 549460 h 635185"/>
              <a:gd name="connsiteX51" fmla="*/ 558800 w 747178"/>
              <a:gd name="connsiteY51" fmla="*/ 546285 h 635185"/>
              <a:gd name="connsiteX52" fmla="*/ 568325 w 747178"/>
              <a:gd name="connsiteY52" fmla="*/ 543110 h 635185"/>
              <a:gd name="connsiteX53" fmla="*/ 581025 w 747178"/>
              <a:gd name="connsiteY53" fmla="*/ 539935 h 635185"/>
              <a:gd name="connsiteX54" fmla="*/ 609600 w 747178"/>
              <a:gd name="connsiteY54" fmla="*/ 530410 h 635185"/>
              <a:gd name="connsiteX55" fmla="*/ 619125 w 747178"/>
              <a:gd name="connsiteY55" fmla="*/ 527235 h 635185"/>
              <a:gd name="connsiteX56" fmla="*/ 650875 w 747178"/>
              <a:gd name="connsiteY56" fmla="*/ 514535 h 635185"/>
              <a:gd name="connsiteX57" fmla="*/ 666750 w 747178"/>
              <a:gd name="connsiteY57" fmla="*/ 505010 h 635185"/>
              <a:gd name="connsiteX58" fmla="*/ 679450 w 747178"/>
              <a:gd name="connsiteY58" fmla="*/ 498660 h 635185"/>
              <a:gd name="connsiteX59" fmla="*/ 688975 w 747178"/>
              <a:gd name="connsiteY59" fmla="*/ 485960 h 635185"/>
              <a:gd name="connsiteX60" fmla="*/ 698500 w 747178"/>
              <a:gd name="connsiteY60" fmla="*/ 476435 h 635185"/>
              <a:gd name="connsiteX61" fmla="*/ 708025 w 747178"/>
              <a:gd name="connsiteY61" fmla="*/ 460560 h 635185"/>
              <a:gd name="connsiteX62" fmla="*/ 720725 w 747178"/>
              <a:gd name="connsiteY62" fmla="*/ 444685 h 635185"/>
              <a:gd name="connsiteX63" fmla="*/ 723900 w 747178"/>
              <a:gd name="connsiteY63" fmla="*/ 435160 h 635185"/>
              <a:gd name="connsiteX64" fmla="*/ 736600 w 747178"/>
              <a:gd name="connsiteY64" fmla="*/ 416110 h 635185"/>
              <a:gd name="connsiteX65" fmla="*/ 739775 w 747178"/>
              <a:gd name="connsiteY65" fmla="*/ 400235 h 635185"/>
              <a:gd name="connsiteX66" fmla="*/ 742950 w 747178"/>
              <a:gd name="connsiteY66" fmla="*/ 390710 h 635185"/>
              <a:gd name="connsiteX67" fmla="*/ 742950 w 747178"/>
              <a:gd name="connsiteY67" fmla="*/ 298635 h 635185"/>
              <a:gd name="connsiteX68" fmla="*/ 736600 w 747178"/>
              <a:gd name="connsiteY68" fmla="*/ 285935 h 635185"/>
              <a:gd name="connsiteX69" fmla="*/ 723900 w 747178"/>
              <a:gd name="connsiteY69" fmla="*/ 260535 h 635185"/>
              <a:gd name="connsiteX70" fmla="*/ 711200 w 747178"/>
              <a:gd name="connsiteY70" fmla="*/ 251010 h 635185"/>
              <a:gd name="connsiteX71" fmla="*/ 698500 w 747178"/>
              <a:gd name="connsiteY71" fmla="*/ 228785 h 635185"/>
              <a:gd name="connsiteX72" fmla="*/ 692150 w 747178"/>
              <a:gd name="connsiteY72" fmla="*/ 219260 h 635185"/>
              <a:gd name="connsiteX73" fmla="*/ 666750 w 747178"/>
              <a:gd name="connsiteY73" fmla="*/ 193860 h 635185"/>
              <a:gd name="connsiteX74" fmla="*/ 657225 w 747178"/>
              <a:gd name="connsiteY74" fmla="*/ 174810 h 635185"/>
              <a:gd name="connsiteX75" fmla="*/ 647700 w 747178"/>
              <a:gd name="connsiteY75" fmla="*/ 168460 h 635185"/>
              <a:gd name="connsiteX76" fmla="*/ 628650 w 747178"/>
              <a:gd name="connsiteY76" fmla="*/ 146235 h 635185"/>
              <a:gd name="connsiteX77" fmla="*/ 622300 w 747178"/>
              <a:gd name="connsiteY77" fmla="*/ 136710 h 635185"/>
              <a:gd name="connsiteX78" fmla="*/ 587375 w 747178"/>
              <a:gd name="connsiteY78" fmla="*/ 114485 h 635185"/>
              <a:gd name="connsiteX79" fmla="*/ 568325 w 747178"/>
              <a:gd name="connsiteY79" fmla="*/ 101785 h 635185"/>
              <a:gd name="connsiteX80" fmla="*/ 555625 w 747178"/>
              <a:gd name="connsiteY80" fmla="*/ 92260 h 635185"/>
              <a:gd name="connsiteX81" fmla="*/ 542925 w 747178"/>
              <a:gd name="connsiteY81" fmla="*/ 85910 h 635185"/>
              <a:gd name="connsiteX82" fmla="*/ 533400 w 747178"/>
              <a:gd name="connsiteY82" fmla="*/ 79560 h 635185"/>
              <a:gd name="connsiteX83" fmla="*/ 523875 w 747178"/>
              <a:gd name="connsiteY83" fmla="*/ 76385 h 635185"/>
              <a:gd name="connsiteX84" fmla="*/ 501650 w 747178"/>
              <a:gd name="connsiteY84" fmla="*/ 60510 h 635185"/>
              <a:gd name="connsiteX85" fmla="*/ 485775 w 747178"/>
              <a:gd name="connsiteY85" fmla="*/ 54160 h 635185"/>
              <a:gd name="connsiteX86" fmla="*/ 457200 w 747178"/>
              <a:gd name="connsiteY86" fmla="*/ 38285 h 635185"/>
              <a:gd name="connsiteX87" fmla="*/ 447675 w 747178"/>
              <a:gd name="connsiteY87" fmla="*/ 35110 h 635185"/>
              <a:gd name="connsiteX88" fmla="*/ 422275 w 747178"/>
              <a:gd name="connsiteY88" fmla="*/ 19235 h 635185"/>
              <a:gd name="connsiteX89" fmla="*/ 400050 w 747178"/>
              <a:gd name="connsiteY89" fmla="*/ 9710 h 635185"/>
              <a:gd name="connsiteX90" fmla="*/ 381000 w 747178"/>
              <a:gd name="connsiteY90" fmla="*/ 3360 h 635185"/>
              <a:gd name="connsiteX91" fmla="*/ 371475 w 747178"/>
              <a:gd name="connsiteY91" fmla="*/ 185 h 635185"/>
              <a:gd name="connsiteX92" fmla="*/ 295275 w 747178"/>
              <a:gd name="connsiteY92" fmla="*/ 3360 h 635185"/>
              <a:gd name="connsiteX93" fmla="*/ 298450 w 747178"/>
              <a:gd name="connsiteY93" fmla="*/ 3360 h 6351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</a:cxnLst>
            <a:rect l="l" t="t" r="r" b="b"/>
            <a:pathLst>
              <a:path w="747178" h="635185">
                <a:moveTo>
                  <a:pt x="298450" y="3360"/>
                </a:moveTo>
                <a:lnTo>
                  <a:pt x="152400" y="50985"/>
                </a:lnTo>
                <a:cubicBezTo>
                  <a:pt x="146993" y="52787"/>
                  <a:pt x="141881" y="55387"/>
                  <a:pt x="136525" y="57335"/>
                </a:cubicBezTo>
                <a:cubicBezTo>
                  <a:pt x="130235" y="59622"/>
                  <a:pt x="123044" y="59972"/>
                  <a:pt x="117475" y="63685"/>
                </a:cubicBezTo>
                <a:cubicBezTo>
                  <a:pt x="93826" y="79451"/>
                  <a:pt x="122871" y="59188"/>
                  <a:pt x="98425" y="79560"/>
                </a:cubicBezTo>
                <a:cubicBezTo>
                  <a:pt x="95494" y="82003"/>
                  <a:pt x="92075" y="83793"/>
                  <a:pt x="88900" y="85910"/>
                </a:cubicBezTo>
                <a:cubicBezTo>
                  <a:pt x="86783" y="89085"/>
                  <a:pt x="85248" y="92737"/>
                  <a:pt x="82550" y="95435"/>
                </a:cubicBezTo>
                <a:cubicBezTo>
                  <a:pt x="79852" y="98133"/>
                  <a:pt x="75409" y="98805"/>
                  <a:pt x="73025" y="101785"/>
                </a:cubicBezTo>
                <a:cubicBezTo>
                  <a:pt x="70934" y="104398"/>
                  <a:pt x="71706" y="108525"/>
                  <a:pt x="69850" y="111310"/>
                </a:cubicBezTo>
                <a:cubicBezTo>
                  <a:pt x="67359" y="115046"/>
                  <a:pt x="63200" y="117386"/>
                  <a:pt x="60325" y="120835"/>
                </a:cubicBezTo>
                <a:cubicBezTo>
                  <a:pt x="35346" y="150810"/>
                  <a:pt x="69893" y="111246"/>
                  <a:pt x="50800" y="139885"/>
                </a:cubicBezTo>
                <a:cubicBezTo>
                  <a:pt x="48309" y="143621"/>
                  <a:pt x="44450" y="146235"/>
                  <a:pt x="41275" y="149410"/>
                </a:cubicBezTo>
                <a:cubicBezTo>
                  <a:pt x="33295" y="173351"/>
                  <a:pt x="44060" y="143841"/>
                  <a:pt x="31750" y="168460"/>
                </a:cubicBezTo>
                <a:cubicBezTo>
                  <a:pt x="30253" y="171453"/>
                  <a:pt x="30072" y="174992"/>
                  <a:pt x="28575" y="177985"/>
                </a:cubicBezTo>
                <a:cubicBezTo>
                  <a:pt x="26868" y="181398"/>
                  <a:pt x="23775" y="184023"/>
                  <a:pt x="22225" y="187510"/>
                </a:cubicBezTo>
                <a:cubicBezTo>
                  <a:pt x="19507" y="193627"/>
                  <a:pt x="19588" y="200991"/>
                  <a:pt x="15875" y="206560"/>
                </a:cubicBezTo>
                <a:cubicBezTo>
                  <a:pt x="13758" y="209735"/>
                  <a:pt x="11232" y="212672"/>
                  <a:pt x="9525" y="216085"/>
                </a:cubicBezTo>
                <a:cubicBezTo>
                  <a:pt x="5687" y="223760"/>
                  <a:pt x="4259" y="237614"/>
                  <a:pt x="3175" y="244660"/>
                </a:cubicBezTo>
                <a:cubicBezTo>
                  <a:pt x="2037" y="252057"/>
                  <a:pt x="1058" y="259477"/>
                  <a:pt x="0" y="266885"/>
                </a:cubicBezTo>
                <a:cubicBezTo>
                  <a:pt x="1076" y="280870"/>
                  <a:pt x="2116" y="310275"/>
                  <a:pt x="6350" y="327210"/>
                </a:cubicBezTo>
                <a:cubicBezTo>
                  <a:pt x="7973" y="333704"/>
                  <a:pt x="8987" y="340691"/>
                  <a:pt x="12700" y="346260"/>
                </a:cubicBezTo>
                <a:cubicBezTo>
                  <a:pt x="16933" y="352610"/>
                  <a:pt x="22987" y="358070"/>
                  <a:pt x="25400" y="365310"/>
                </a:cubicBezTo>
                <a:cubicBezTo>
                  <a:pt x="33170" y="388620"/>
                  <a:pt x="27017" y="379627"/>
                  <a:pt x="41275" y="393885"/>
                </a:cubicBezTo>
                <a:lnTo>
                  <a:pt x="47625" y="412935"/>
                </a:lnTo>
                <a:cubicBezTo>
                  <a:pt x="48683" y="416110"/>
                  <a:pt x="48944" y="419675"/>
                  <a:pt x="50800" y="422460"/>
                </a:cubicBezTo>
                <a:cubicBezTo>
                  <a:pt x="52917" y="425635"/>
                  <a:pt x="55600" y="428498"/>
                  <a:pt x="57150" y="431985"/>
                </a:cubicBezTo>
                <a:cubicBezTo>
                  <a:pt x="72263" y="465990"/>
                  <a:pt x="55479" y="439004"/>
                  <a:pt x="69850" y="460560"/>
                </a:cubicBezTo>
                <a:cubicBezTo>
                  <a:pt x="70908" y="466910"/>
                  <a:pt x="72227" y="473222"/>
                  <a:pt x="73025" y="479610"/>
                </a:cubicBezTo>
                <a:cubicBezTo>
                  <a:pt x="74344" y="490164"/>
                  <a:pt x="74240" y="500906"/>
                  <a:pt x="76200" y="511360"/>
                </a:cubicBezTo>
                <a:cubicBezTo>
                  <a:pt x="77434" y="517939"/>
                  <a:pt x="80433" y="524060"/>
                  <a:pt x="82550" y="530410"/>
                </a:cubicBezTo>
                <a:cubicBezTo>
                  <a:pt x="86932" y="543555"/>
                  <a:pt x="83869" y="537150"/>
                  <a:pt x="92075" y="549460"/>
                </a:cubicBezTo>
                <a:cubicBezTo>
                  <a:pt x="93133" y="553693"/>
                  <a:pt x="93299" y="558257"/>
                  <a:pt x="95250" y="562160"/>
                </a:cubicBezTo>
                <a:cubicBezTo>
                  <a:pt x="104510" y="580681"/>
                  <a:pt x="104378" y="578829"/>
                  <a:pt x="117475" y="587560"/>
                </a:cubicBezTo>
                <a:cubicBezTo>
                  <a:pt x="119592" y="590735"/>
                  <a:pt x="120845" y="594701"/>
                  <a:pt x="123825" y="597085"/>
                </a:cubicBezTo>
                <a:cubicBezTo>
                  <a:pt x="126438" y="599176"/>
                  <a:pt x="130357" y="598763"/>
                  <a:pt x="133350" y="600260"/>
                </a:cubicBezTo>
                <a:cubicBezTo>
                  <a:pt x="136763" y="601967"/>
                  <a:pt x="139255" y="605403"/>
                  <a:pt x="142875" y="606610"/>
                </a:cubicBezTo>
                <a:cubicBezTo>
                  <a:pt x="148982" y="608646"/>
                  <a:pt x="155591" y="608633"/>
                  <a:pt x="161925" y="609785"/>
                </a:cubicBezTo>
                <a:cubicBezTo>
                  <a:pt x="195934" y="615968"/>
                  <a:pt x="157975" y="610921"/>
                  <a:pt x="212725" y="616135"/>
                </a:cubicBezTo>
                <a:cubicBezTo>
                  <a:pt x="227131" y="617507"/>
                  <a:pt x="258124" y="620619"/>
                  <a:pt x="273050" y="622485"/>
                </a:cubicBezTo>
                <a:cubicBezTo>
                  <a:pt x="280476" y="623413"/>
                  <a:pt x="287893" y="624430"/>
                  <a:pt x="295275" y="625660"/>
                </a:cubicBezTo>
                <a:cubicBezTo>
                  <a:pt x="300598" y="626547"/>
                  <a:pt x="305795" y="628166"/>
                  <a:pt x="311150" y="628835"/>
                </a:cubicBezTo>
                <a:cubicBezTo>
                  <a:pt x="386307" y="638230"/>
                  <a:pt x="315919" y="626984"/>
                  <a:pt x="365125" y="635185"/>
                </a:cubicBezTo>
                <a:cubicBezTo>
                  <a:pt x="395817" y="634127"/>
                  <a:pt x="426550" y="633926"/>
                  <a:pt x="457200" y="632010"/>
                </a:cubicBezTo>
                <a:cubicBezTo>
                  <a:pt x="460540" y="631801"/>
                  <a:pt x="463940" y="630691"/>
                  <a:pt x="466725" y="628835"/>
                </a:cubicBezTo>
                <a:cubicBezTo>
                  <a:pt x="470461" y="626344"/>
                  <a:pt x="473075" y="622485"/>
                  <a:pt x="476250" y="619310"/>
                </a:cubicBezTo>
                <a:cubicBezTo>
                  <a:pt x="477308" y="616135"/>
                  <a:pt x="477928" y="612778"/>
                  <a:pt x="479425" y="609785"/>
                </a:cubicBezTo>
                <a:cubicBezTo>
                  <a:pt x="481132" y="606372"/>
                  <a:pt x="484435" y="603833"/>
                  <a:pt x="485775" y="600260"/>
                </a:cubicBezTo>
                <a:cubicBezTo>
                  <a:pt x="486194" y="599144"/>
                  <a:pt x="489360" y="578316"/>
                  <a:pt x="492125" y="574860"/>
                </a:cubicBezTo>
                <a:cubicBezTo>
                  <a:pt x="499510" y="565629"/>
                  <a:pt x="511553" y="568258"/>
                  <a:pt x="520700" y="562160"/>
                </a:cubicBezTo>
                <a:cubicBezTo>
                  <a:pt x="523875" y="560043"/>
                  <a:pt x="526738" y="557360"/>
                  <a:pt x="530225" y="555810"/>
                </a:cubicBezTo>
                <a:cubicBezTo>
                  <a:pt x="536342" y="553092"/>
                  <a:pt x="542925" y="551577"/>
                  <a:pt x="549275" y="549460"/>
                </a:cubicBezTo>
                <a:lnTo>
                  <a:pt x="558800" y="546285"/>
                </a:lnTo>
                <a:cubicBezTo>
                  <a:pt x="561975" y="545227"/>
                  <a:pt x="565078" y="543922"/>
                  <a:pt x="568325" y="543110"/>
                </a:cubicBezTo>
                <a:cubicBezTo>
                  <a:pt x="572558" y="542052"/>
                  <a:pt x="576845" y="541189"/>
                  <a:pt x="581025" y="539935"/>
                </a:cubicBezTo>
                <a:cubicBezTo>
                  <a:pt x="590642" y="537050"/>
                  <a:pt x="600075" y="533585"/>
                  <a:pt x="609600" y="530410"/>
                </a:cubicBezTo>
                <a:cubicBezTo>
                  <a:pt x="612775" y="529352"/>
                  <a:pt x="616340" y="529091"/>
                  <a:pt x="619125" y="527235"/>
                </a:cubicBezTo>
                <a:cubicBezTo>
                  <a:pt x="635061" y="516611"/>
                  <a:pt x="624981" y="521933"/>
                  <a:pt x="650875" y="514535"/>
                </a:cubicBezTo>
                <a:cubicBezTo>
                  <a:pt x="656167" y="511360"/>
                  <a:pt x="661355" y="508007"/>
                  <a:pt x="666750" y="505010"/>
                </a:cubicBezTo>
                <a:cubicBezTo>
                  <a:pt x="670887" y="502711"/>
                  <a:pt x="675856" y="501740"/>
                  <a:pt x="679450" y="498660"/>
                </a:cubicBezTo>
                <a:cubicBezTo>
                  <a:pt x="683468" y="495216"/>
                  <a:pt x="685531" y="489978"/>
                  <a:pt x="688975" y="485960"/>
                </a:cubicBezTo>
                <a:cubicBezTo>
                  <a:pt x="691897" y="482551"/>
                  <a:pt x="695806" y="480027"/>
                  <a:pt x="698500" y="476435"/>
                </a:cubicBezTo>
                <a:cubicBezTo>
                  <a:pt x="702203" y="471498"/>
                  <a:pt x="704486" y="465616"/>
                  <a:pt x="708025" y="460560"/>
                </a:cubicBezTo>
                <a:cubicBezTo>
                  <a:pt x="711911" y="455008"/>
                  <a:pt x="716492" y="449977"/>
                  <a:pt x="720725" y="444685"/>
                </a:cubicBezTo>
                <a:cubicBezTo>
                  <a:pt x="721783" y="441510"/>
                  <a:pt x="722275" y="438086"/>
                  <a:pt x="723900" y="435160"/>
                </a:cubicBezTo>
                <a:cubicBezTo>
                  <a:pt x="727606" y="428489"/>
                  <a:pt x="733442" y="423058"/>
                  <a:pt x="736600" y="416110"/>
                </a:cubicBezTo>
                <a:cubicBezTo>
                  <a:pt x="738833" y="411197"/>
                  <a:pt x="738466" y="405470"/>
                  <a:pt x="739775" y="400235"/>
                </a:cubicBezTo>
                <a:cubicBezTo>
                  <a:pt x="740587" y="396988"/>
                  <a:pt x="741892" y="393885"/>
                  <a:pt x="742950" y="390710"/>
                </a:cubicBezTo>
                <a:cubicBezTo>
                  <a:pt x="747820" y="351751"/>
                  <a:pt x="749308" y="351617"/>
                  <a:pt x="742950" y="298635"/>
                </a:cubicBezTo>
                <a:cubicBezTo>
                  <a:pt x="742386" y="293936"/>
                  <a:pt x="738522" y="290260"/>
                  <a:pt x="736600" y="285935"/>
                </a:cubicBezTo>
                <a:cubicBezTo>
                  <a:pt x="732962" y="277749"/>
                  <a:pt x="730647" y="267282"/>
                  <a:pt x="723900" y="260535"/>
                </a:cubicBezTo>
                <a:cubicBezTo>
                  <a:pt x="720158" y="256793"/>
                  <a:pt x="715433" y="254185"/>
                  <a:pt x="711200" y="251010"/>
                </a:cubicBezTo>
                <a:cubicBezTo>
                  <a:pt x="706048" y="235553"/>
                  <a:pt x="710514" y="245604"/>
                  <a:pt x="698500" y="228785"/>
                </a:cubicBezTo>
                <a:cubicBezTo>
                  <a:pt x="696282" y="225680"/>
                  <a:pt x="694717" y="222084"/>
                  <a:pt x="692150" y="219260"/>
                </a:cubicBezTo>
                <a:cubicBezTo>
                  <a:pt x="684096" y="210400"/>
                  <a:pt x="666750" y="193860"/>
                  <a:pt x="666750" y="193860"/>
                </a:cubicBezTo>
                <a:cubicBezTo>
                  <a:pt x="664168" y="186113"/>
                  <a:pt x="663380" y="180965"/>
                  <a:pt x="657225" y="174810"/>
                </a:cubicBezTo>
                <a:cubicBezTo>
                  <a:pt x="654527" y="172112"/>
                  <a:pt x="650875" y="170577"/>
                  <a:pt x="647700" y="168460"/>
                </a:cubicBezTo>
                <a:cubicBezTo>
                  <a:pt x="624358" y="129556"/>
                  <a:pt x="650639" y="168224"/>
                  <a:pt x="628650" y="146235"/>
                </a:cubicBezTo>
                <a:cubicBezTo>
                  <a:pt x="625952" y="143537"/>
                  <a:pt x="625136" y="139263"/>
                  <a:pt x="622300" y="136710"/>
                </a:cubicBezTo>
                <a:cubicBezTo>
                  <a:pt x="601655" y="118129"/>
                  <a:pt x="604590" y="120223"/>
                  <a:pt x="587375" y="114485"/>
                </a:cubicBezTo>
                <a:cubicBezTo>
                  <a:pt x="565209" y="92319"/>
                  <a:pt x="589768" y="114038"/>
                  <a:pt x="568325" y="101785"/>
                </a:cubicBezTo>
                <a:cubicBezTo>
                  <a:pt x="563731" y="99160"/>
                  <a:pt x="560112" y="95065"/>
                  <a:pt x="555625" y="92260"/>
                </a:cubicBezTo>
                <a:cubicBezTo>
                  <a:pt x="551611" y="89752"/>
                  <a:pt x="547034" y="88258"/>
                  <a:pt x="542925" y="85910"/>
                </a:cubicBezTo>
                <a:cubicBezTo>
                  <a:pt x="539612" y="84017"/>
                  <a:pt x="536813" y="81267"/>
                  <a:pt x="533400" y="79560"/>
                </a:cubicBezTo>
                <a:cubicBezTo>
                  <a:pt x="530407" y="78063"/>
                  <a:pt x="526868" y="77882"/>
                  <a:pt x="523875" y="76385"/>
                </a:cubicBezTo>
                <a:cubicBezTo>
                  <a:pt x="511973" y="70434"/>
                  <a:pt x="514593" y="67701"/>
                  <a:pt x="501650" y="60510"/>
                </a:cubicBezTo>
                <a:cubicBezTo>
                  <a:pt x="496668" y="57742"/>
                  <a:pt x="490873" y="56709"/>
                  <a:pt x="485775" y="54160"/>
                </a:cubicBezTo>
                <a:cubicBezTo>
                  <a:pt x="461690" y="42117"/>
                  <a:pt x="478604" y="47458"/>
                  <a:pt x="457200" y="38285"/>
                </a:cubicBezTo>
                <a:cubicBezTo>
                  <a:pt x="454124" y="36967"/>
                  <a:pt x="450613" y="36713"/>
                  <a:pt x="447675" y="35110"/>
                </a:cubicBezTo>
                <a:cubicBezTo>
                  <a:pt x="438910" y="30329"/>
                  <a:pt x="431747" y="22392"/>
                  <a:pt x="422275" y="19235"/>
                </a:cubicBezTo>
                <a:cubicBezTo>
                  <a:pt x="391614" y="9015"/>
                  <a:pt x="439284" y="25403"/>
                  <a:pt x="400050" y="9710"/>
                </a:cubicBezTo>
                <a:cubicBezTo>
                  <a:pt x="393835" y="7224"/>
                  <a:pt x="387350" y="5477"/>
                  <a:pt x="381000" y="3360"/>
                </a:cubicBezTo>
                <a:lnTo>
                  <a:pt x="371475" y="185"/>
                </a:lnTo>
                <a:cubicBezTo>
                  <a:pt x="346075" y="1243"/>
                  <a:pt x="320628" y="1482"/>
                  <a:pt x="295275" y="3360"/>
                </a:cubicBezTo>
                <a:cubicBezTo>
                  <a:pt x="284746" y="4140"/>
                  <a:pt x="322263" y="-4578"/>
                  <a:pt x="298450" y="336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152196" y="299737"/>
            <a:ext cx="18455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ntisense probe</a:t>
            </a:r>
          </a:p>
          <a:p>
            <a:pPr algn="ctr"/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NEAT1_2)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4569249" y="321490"/>
            <a:ext cx="33226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ense probe </a:t>
            </a:r>
          </a:p>
          <a:p>
            <a:pPr algn="ctr"/>
            <a:r>
              <a:rPr kumimoji="1"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negative control)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2862847" y="989923"/>
            <a:ext cx="1656962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r>
              <a:rPr kumimoji="1" lang="en-US" altLang="ja-JP" sz="1400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/Hoechst</a:t>
            </a:r>
            <a:endParaRPr kumimoji="1" lang="ja-JP" altLang="en-US" sz="1400" b="1" dirty="0">
              <a:solidFill>
                <a:schemeClr val="tx2">
                  <a:lumMod val="60000"/>
                  <a:lumOff val="40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3545359" y="3929523"/>
            <a:ext cx="1438670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endParaRPr kumimoji="1" lang="ja-JP" altLang="en-US" sz="14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5843647" y="998290"/>
            <a:ext cx="1896452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ense probe</a:t>
            </a:r>
            <a:r>
              <a:rPr kumimoji="1" lang="en-US" altLang="ja-JP" sz="1400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/Hoechst</a:t>
            </a:r>
            <a:endParaRPr kumimoji="1" lang="ja-JP" altLang="en-US" sz="1400" b="1" dirty="0">
              <a:solidFill>
                <a:schemeClr val="tx2">
                  <a:lumMod val="60000"/>
                  <a:lumOff val="40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6527213" y="3938240"/>
            <a:ext cx="1438670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ense probe</a:t>
            </a:r>
            <a:endParaRPr kumimoji="1" lang="ja-JP" altLang="en-US" sz="14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2316118" y="2564885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chemeClr val="bg1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*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5764480" y="2516598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chemeClr val="bg1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*</a:t>
            </a:r>
            <a:endParaRPr lang="ja-JP" alt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071056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</TotalTime>
  <Words>23</Words>
  <Application>Microsoft Office PowerPoint</Application>
  <PresentationFormat>画面に合わせる (4:3)</PresentationFormat>
  <Paragraphs>12</Paragraphs>
  <Slides>1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Arial Unicode MS</vt:lpstr>
      <vt:lpstr>ＭＳ Ｐゴシック</vt:lpstr>
      <vt:lpstr>ＭＳ 明朝</vt:lpstr>
      <vt:lpstr>Arial</vt:lpstr>
      <vt:lpstr>Calibri</vt:lpstr>
      <vt:lpstr>Times New Roman</vt:lpstr>
      <vt:lpstr>Office ​​テーマ</vt:lpstr>
      <vt:lpstr>Image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nori</dc:creator>
  <cp:lastModifiedBy>Yoshinori</cp:lastModifiedBy>
  <cp:revision>37</cp:revision>
  <cp:lastPrinted>2012-12-12T09:07:08Z</cp:lastPrinted>
  <dcterms:created xsi:type="dcterms:W3CDTF">2012-11-08T08:31:02Z</dcterms:created>
  <dcterms:modified xsi:type="dcterms:W3CDTF">2013-06-18T01:53:13Z</dcterms:modified>
</cp:coreProperties>
</file>